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7" r:id="rId2"/>
    <p:sldId id="258" r:id="rId3"/>
  </p:sldIdLst>
  <p:sldSz cx="9144000" cy="6858000" type="screen4x3"/>
  <p:notesSz cx="6858000" cy="93821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437FF"/>
    <a:srgbClr val="00FDFF"/>
    <a:srgbClr val="33CCFF"/>
    <a:srgbClr val="B2B2B2"/>
    <a:srgbClr val="FFCC66"/>
    <a:srgbClr val="FFFFFF"/>
    <a:srgbClr val="339966"/>
    <a:srgbClr val="339933"/>
    <a:srgbClr val="33CC33"/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8389128-E705-4C11-AC5D-CFDCAD4452F3}" v="95" dt="2021-09-28T13:49:06.72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422"/>
    <p:restoredTop sz="94708"/>
  </p:normalViewPr>
  <p:slideViewPr>
    <p:cSldViewPr snapToGrid="0" snapToObjects="1">
      <p:cViewPr varScale="1">
        <p:scale>
          <a:sx n="102" d="100"/>
          <a:sy n="102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ois Hoyer" userId="8c378a1a5b622d94" providerId="LiveId" clId="{78389128-E705-4C11-AC5D-CFDCAD4452F3}"/>
    <pc:docChg chg="undo custSel addSld modSld">
      <pc:chgData name="Lois Hoyer" userId="8c378a1a5b622d94" providerId="LiveId" clId="{78389128-E705-4C11-AC5D-CFDCAD4452F3}" dt="2021-10-07T21:29:02.537" v="8213" actId="20577"/>
      <pc:docMkLst>
        <pc:docMk/>
      </pc:docMkLst>
      <pc:sldChg chg="addSp delSp modSp mod">
        <pc:chgData name="Lois Hoyer" userId="8c378a1a5b622d94" providerId="LiveId" clId="{78389128-E705-4C11-AC5D-CFDCAD4452F3}" dt="2021-10-03T14:43:34.397" v="7435" actId="1035"/>
        <pc:sldMkLst>
          <pc:docMk/>
          <pc:sldMk cId="954159042" sldId="257"/>
        </pc:sldMkLst>
        <pc:spChg chg="add del">
          <ac:chgData name="Lois Hoyer" userId="8c378a1a5b622d94" providerId="LiveId" clId="{78389128-E705-4C11-AC5D-CFDCAD4452F3}" dt="2021-09-02T21:51:54.819" v="737" actId="478"/>
          <ac:spMkLst>
            <pc:docMk/>
            <pc:sldMk cId="954159042" sldId="257"/>
            <ac:spMk id="3" creationId="{DDF4178A-B689-4E6C-95A8-D9CB7F2B0410}"/>
          </ac:spMkLst>
        </pc:spChg>
        <pc:spChg chg="add del mod">
          <ac:chgData name="Lois Hoyer" userId="8c378a1a5b622d94" providerId="LiveId" clId="{78389128-E705-4C11-AC5D-CFDCAD4452F3}" dt="2021-09-02T21:51:51.159" v="736" actId="478"/>
          <ac:spMkLst>
            <pc:docMk/>
            <pc:sldMk cId="954159042" sldId="257"/>
            <ac:spMk id="4" creationId="{8FB86AB2-E6ED-4C0F-A624-338840C9C7E7}"/>
          </ac:spMkLst>
        </pc:spChg>
        <pc:spChg chg="mod">
          <ac:chgData name="Lois Hoyer" userId="8c378a1a5b622d94" providerId="LiveId" clId="{78389128-E705-4C11-AC5D-CFDCAD4452F3}" dt="2021-09-28T13:49:41.623" v="7428" actId="20577"/>
          <ac:spMkLst>
            <pc:docMk/>
            <pc:sldMk cId="954159042" sldId="257"/>
            <ac:spMk id="5" creationId="{96050657-E3F1-48B8-ACFC-2374102DE33B}"/>
          </ac:spMkLst>
        </pc:spChg>
        <pc:spChg chg="add del mod">
          <ac:chgData name="Lois Hoyer" userId="8c378a1a5b622d94" providerId="LiveId" clId="{78389128-E705-4C11-AC5D-CFDCAD4452F3}" dt="2021-09-02T21:51:47.835" v="735" actId="478"/>
          <ac:spMkLst>
            <pc:docMk/>
            <pc:sldMk cId="954159042" sldId="257"/>
            <ac:spMk id="6" creationId="{A522C82D-0473-44F2-AFFE-D84821034589}"/>
          </ac:spMkLst>
        </pc:spChg>
        <pc:spChg chg="del mod">
          <ac:chgData name="Lois Hoyer" userId="8c378a1a5b622d94" providerId="LiveId" clId="{78389128-E705-4C11-AC5D-CFDCAD4452F3}" dt="2021-09-20T18:01:19.839" v="3397" actId="478"/>
          <ac:spMkLst>
            <pc:docMk/>
            <pc:sldMk cId="954159042" sldId="257"/>
            <ac:spMk id="7" creationId="{567CD372-6159-43D9-AFF4-B6C0CCC9D460}"/>
          </ac:spMkLst>
        </pc:spChg>
        <pc:spChg chg="add mod">
          <ac:chgData name="Lois Hoyer" userId="8c378a1a5b622d94" providerId="LiveId" clId="{78389128-E705-4C11-AC5D-CFDCAD4452F3}" dt="2021-09-27T20:47:49.825" v="6450" actId="1076"/>
          <ac:spMkLst>
            <pc:docMk/>
            <pc:sldMk cId="954159042" sldId="257"/>
            <ac:spMk id="9" creationId="{A04F3558-C501-4360-BD3C-08395FCD6E44}"/>
          </ac:spMkLst>
        </pc:spChg>
        <pc:spChg chg="del mod">
          <ac:chgData name="Lois Hoyer" userId="8c378a1a5b622d94" providerId="LiveId" clId="{78389128-E705-4C11-AC5D-CFDCAD4452F3}" dt="2021-09-15T20:47:41.981" v="2881" actId="21"/>
          <ac:spMkLst>
            <pc:docMk/>
            <pc:sldMk cId="954159042" sldId="257"/>
            <ac:spMk id="19" creationId="{87AC59A7-4AB2-45F2-9A2C-D24B2A2833F1}"/>
          </ac:spMkLst>
        </pc:spChg>
        <pc:spChg chg="add 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128" creationId="{0C4BFF2E-2334-498A-A733-1560F378A47D}"/>
          </ac:spMkLst>
        </pc:spChg>
        <pc:spChg chg="add 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129" creationId="{3251F4A9-BA68-499C-BB90-15DD4104D67F}"/>
          </ac:spMkLst>
        </pc:spChg>
        <pc:spChg chg="add mod">
          <ac:chgData name="Lois Hoyer" userId="8c378a1a5b622d94" providerId="LiveId" clId="{78389128-E705-4C11-AC5D-CFDCAD4452F3}" dt="2021-10-03T14:43:18.393" v="7431" actId="1036"/>
          <ac:spMkLst>
            <pc:docMk/>
            <pc:sldMk cId="954159042" sldId="257"/>
            <ac:spMk id="132" creationId="{52343984-29E7-4F5A-9B70-9D8BDC1F1C3E}"/>
          </ac:spMkLst>
        </pc:spChg>
        <pc:spChg chg="add mod">
          <ac:chgData name="Lois Hoyer" userId="8c378a1a5b622d94" providerId="LiveId" clId="{78389128-E705-4C11-AC5D-CFDCAD4452F3}" dt="2021-10-03T14:43:23.958" v="7432" actId="1036"/>
          <ac:spMkLst>
            <pc:docMk/>
            <pc:sldMk cId="954159042" sldId="257"/>
            <ac:spMk id="133" creationId="{D82B84C6-1F48-476D-97DF-14E8C909151A}"/>
          </ac:spMkLst>
        </pc:spChg>
        <pc:spChg chg="add mod">
          <ac:chgData name="Lois Hoyer" userId="8c378a1a5b622d94" providerId="LiveId" clId="{78389128-E705-4C11-AC5D-CFDCAD4452F3}" dt="2021-10-03T14:43:28.193" v="7433" actId="1036"/>
          <ac:spMkLst>
            <pc:docMk/>
            <pc:sldMk cId="954159042" sldId="257"/>
            <ac:spMk id="134" creationId="{6CADED45-FEBA-4DD2-AEAC-1B08DEFD532D}"/>
          </ac:spMkLst>
        </pc:spChg>
        <pc:spChg chg="add mod">
          <ac:chgData name="Lois Hoyer" userId="8c378a1a5b622d94" providerId="LiveId" clId="{78389128-E705-4C11-AC5D-CFDCAD4452F3}" dt="2021-10-03T14:43:34.397" v="7435" actId="1035"/>
          <ac:spMkLst>
            <pc:docMk/>
            <pc:sldMk cId="954159042" sldId="257"/>
            <ac:spMk id="135" creationId="{EA0674FC-44DF-4349-AFD6-EA4C790F2C0A}"/>
          </ac:spMkLst>
        </pc:spChg>
        <pc:spChg chg="add mod">
          <ac:chgData name="Lois Hoyer" userId="8c378a1a5b622d94" providerId="LiveId" clId="{78389128-E705-4C11-AC5D-CFDCAD4452F3}" dt="2021-09-28T13:34:36.981" v="6814" actId="1076"/>
          <ac:spMkLst>
            <pc:docMk/>
            <pc:sldMk cId="954159042" sldId="257"/>
            <ac:spMk id="136" creationId="{F3C6FECD-998F-48A8-83ED-2890F0F2EA19}"/>
          </ac:spMkLst>
        </pc:spChg>
        <pc:spChg chg="add mod">
          <ac:chgData name="Lois Hoyer" userId="8c378a1a5b622d94" providerId="LiveId" clId="{78389128-E705-4C11-AC5D-CFDCAD4452F3}" dt="2021-09-28T13:34:40.156" v="6815" actId="1076"/>
          <ac:spMkLst>
            <pc:docMk/>
            <pc:sldMk cId="954159042" sldId="257"/>
            <ac:spMk id="137" creationId="{52AB61B8-D7F7-453B-B13C-7D5E88811735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38" creationId="{C2C580DE-6F66-43BC-9C02-F2948A146D63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39" creationId="{F3F040EC-7277-4E59-8E9F-BE8A7C64A474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40" creationId="{7F719091-4E76-4404-A2C8-CE5F1C6666B5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41" creationId="{1A003EEE-0313-4B87-ABD6-C8664BE87818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42" creationId="{67552864-7878-4FC8-A734-6BF3022B7D50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43" creationId="{E91690CF-FDA2-495F-B23A-D799773C88D1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44" creationId="{6F46CD4E-0DF1-40C6-A076-3F77E79112AD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45" creationId="{DE24810A-F27A-4ADF-80F0-EB70FA537634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46" creationId="{A6597740-AEFE-4A6E-BBA8-8630C12D7E40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47" creationId="{081D81BE-B068-4FE4-A358-5662082D3C49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48" creationId="{DBC2BC09-28D1-4C5C-B458-5BEF98DAA145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49" creationId="{7783EF5B-E551-4E5B-98FE-F62E77C89CEB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50" creationId="{E47BDEE6-1FED-354C-866D-1150E855C0DE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51" creationId="{14088EE7-0D0C-B346-86D2-8863D17A2FAD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52" creationId="{4CE46E8D-3119-476F-9D73-867FAEF0BCEF}"/>
          </ac:spMkLst>
        </pc:spChg>
        <pc:spChg chg="del mod topLvl">
          <ac:chgData name="Lois Hoyer" userId="8c378a1a5b622d94" providerId="LiveId" clId="{78389128-E705-4C11-AC5D-CFDCAD4452F3}" dt="2021-09-03T20:50:21.179" v="1372" actId="478"/>
          <ac:spMkLst>
            <pc:docMk/>
            <pc:sldMk cId="954159042" sldId="257"/>
            <ac:spMk id="152" creationId="{F3D8D4FD-5680-3B40-9747-BEC282B9D564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53" creationId="{ABAFCB6B-06BF-44FB-A2DF-861176CD3935}"/>
          </ac:spMkLst>
        </pc:spChg>
        <pc:spChg chg="del mod topLvl">
          <ac:chgData name="Lois Hoyer" userId="8c378a1a5b622d94" providerId="LiveId" clId="{78389128-E705-4C11-AC5D-CFDCAD4452F3}" dt="2021-09-03T20:50:21.179" v="1372" actId="478"/>
          <ac:spMkLst>
            <pc:docMk/>
            <pc:sldMk cId="954159042" sldId="257"/>
            <ac:spMk id="153" creationId="{E6101CAE-BB8D-EC4E-A376-6DF9167C6660}"/>
          </ac:spMkLst>
        </pc:spChg>
        <pc:spChg chg="del mod topLvl">
          <ac:chgData name="Lois Hoyer" userId="8c378a1a5b622d94" providerId="LiveId" clId="{78389128-E705-4C11-AC5D-CFDCAD4452F3}" dt="2021-09-03T20:50:21.179" v="1372" actId="478"/>
          <ac:spMkLst>
            <pc:docMk/>
            <pc:sldMk cId="954159042" sldId="257"/>
            <ac:spMk id="154" creationId="{6C9A7B49-8001-2448-B367-E979648C0E52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54" creationId="{EE39DEF8-1BD3-4C70-AE85-6E30A9EBAC9C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55" creationId="{D9F1BA79-E419-4AD7-BCB7-5EB7DAC7E3BC}"/>
          </ac:spMkLst>
        </pc:spChg>
        <pc:spChg chg="del mod topLvl">
          <ac:chgData name="Lois Hoyer" userId="8c378a1a5b622d94" providerId="LiveId" clId="{78389128-E705-4C11-AC5D-CFDCAD4452F3}" dt="2021-09-03T20:50:21.179" v="1372" actId="478"/>
          <ac:spMkLst>
            <pc:docMk/>
            <pc:sldMk cId="954159042" sldId="257"/>
            <ac:spMk id="155" creationId="{FF60F57A-41F4-0A46-9196-4712729E387C}"/>
          </ac:spMkLst>
        </pc:spChg>
        <pc:spChg chg="del mod topLvl">
          <ac:chgData name="Lois Hoyer" userId="8c378a1a5b622d94" providerId="LiveId" clId="{78389128-E705-4C11-AC5D-CFDCAD4452F3}" dt="2021-09-03T20:50:21.179" v="1372" actId="478"/>
          <ac:spMkLst>
            <pc:docMk/>
            <pc:sldMk cId="954159042" sldId="257"/>
            <ac:spMk id="156" creationId="{4567C693-5042-464F-9A67-317B5C3A0A8D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56" creationId="{DBD8D330-C16E-4BC9-A54E-3B91817B7359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57" creationId="{1ACF17DA-E09B-E641-B111-30EE388C3FC2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58" creationId="{E15071A5-0F03-6A46-9E8B-00829A46CDBB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59" creationId="{6BA96F28-2A22-6D42-9CEE-A6DB0C38B0C9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60" creationId="{C3E76E26-5C7D-8848-BB46-5B2E530DCD5C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61" creationId="{F8424D00-05B6-CE4F-BCCE-16CDED4530AE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62" creationId="{87365F4B-0ABB-6343-B0D6-265F7334B295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63" creationId="{91FB8AE8-D5D2-B64A-9C0A-0E8093679156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64" creationId="{E8F7B4BB-5EEB-0B4A-8588-DCC29A320CB8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65" creationId="{051839E9-0386-AB42-A6DF-A5A17026A531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66" creationId="{026A5C82-0419-5140-AAA6-563DADFED43E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67" creationId="{C6435C8B-93BE-384F-A1A6-03657E6953DB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68" creationId="{EF2D7DF4-DFCB-7443-990E-C5D741AB09AA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69" creationId="{181A803C-FAEE-CF40-B340-31C4EE31B1B5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70" creationId="{C9EF19B0-B46A-5C47-9035-E6B9A0C2B353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71" creationId="{81A37607-0604-354D-9EE2-84C9FC55B924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72" creationId="{A80B244B-D767-374D-9E0D-BD4F4B2B6A85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73" creationId="{921C9BD1-E966-BB4F-897B-2E23C26268EF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74" creationId="{B7A2C6DD-64F5-924B-8A11-559C1FF54F24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75" creationId="{CC637010-7190-5D43-9861-9FE9C0B9C637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76" creationId="{0F9A79E5-E715-DF46-94B4-283C75FDF5B5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77" creationId="{0F308568-0608-434B-A937-766A4389557E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78" creationId="{2CCEB257-787F-EA48-8E2C-4B517D5DA5BF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79" creationId="{F9F8D19F-6611-A149-9FDB-2AD22ED6FC74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80" creationId="{D5554AB5-89C4-334C-8587-63F2EE2EC787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81" creationId="{76CB726D-0FF5-E142-8216-B7E957BBEA4F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82" creationId="{816ED7B1-27E2-BD4B-AE4C-62439F9B285D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83" creationId="{C0EB5888-6015-A347-8626-C0078961E8A6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84" creationId="{7BD4F00C-2B22-E64A-96F9-BA6A73143268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85" creationId="{6DEF87D1-6CF1-9340-B95B-B51158692994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86" creationId="{ED460973-2EC4-164C-9230-2E2FC437F608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87" creationId="{A67A168B-CD07-3A4D-9EC6-39232454EF33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188" creationId="{1FA06149-52A1-0E4A-AD9E-246403FB91D3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88" creationId="{CDB00E47-9609-4899-89CE-92D07DAF0A4D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89" creationId="{3AE11909-5EE4-458B-B8FD-E200A9117580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189" creationId="{D7E45AE7-BE73-6D4C-9C3F-FE825C89CEE0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190" creationId="{A4ACA94D-5710-774D-9FFE-98E5980BA3E5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90" creationId="{CA433B86-746B-4A6B-9954-1484FD5D54F1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191" creationId="{434EB71F-528C-2740-9745-8C677E8645E7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91" creationId="{5B6D54BA-1CD3-4731-8E31-5216239A1967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192" creationId="{8D7E5192-FDA1-8E49-874E-98D12860A49E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92" creationId="{F59602C4-EF15-4922-A831-7FA6EFF7F879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93" creationId="{A32B84B0-9632-4A69-80E1-268FCFC2D051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193" creationId="{D1756C9C-093B-6F4B-A1C8-A36277A52F7B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94" creationId="{173B6D2A-6400-4442-87D0-12E3FF54064F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194" creationId="{CF8333CD-E823-9F46-952D-4A9544C8CCB2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195" creationId="{09B71641-662A-1149-900E-6D86F57EE8F1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95" creationId="{27F14F89-99DD-402D-978F-DF08C1CD476D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196" creationId="{0C25A076-CEA7-C947-B00D-7E3AF005DA7F}"/>
          </ac:spMkLst>
        </pc:spChg>
        <pc:spChg chg="add mod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196" creationId="{A7308E60-8E00-4068-9F2D-AA98EA86E0B6}"/>
          </ac:spMkLst>
        </pc:spChg>
        <pc:spChg chg="add mod">
          <ac:chgData name="Lois Hoyer" userId="8c378a1a5b622d94" providerId="LiveId" clId="{78389128-E705-4C11-AC5D-CFDCAD4452F3}" dt="2021-09-28T13:34:45.172" v="6816" actId="1076"/>
          <ac:spMkLst>
            <pc:docMk/>
            <pc:sldMk cId="954159042" sldId="257"/>
            <ac:spMk id="197" creationId="{AF9E27BF-847F-4E61-9982-30F1ABD46B3C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197" creationId="{E2A48959-0F9F-9546-A9E3-A856EE9B562D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198" creationId="{849546D3-6DBC-F844-9BFB-1C23115AC68A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199" creationId="{38157566-17A3-7549-AC6B-3677850FE057}"/>
          </ac:spMkLst>
        </pc:spChg>
        <pc:spChg chg="add mod">
          <ac:chgData name="Lois Hoyer" userId="8c378a1a5b622d94" providerId="LiveId" clId="{78389128-E705-4C11-AC5D-CFDCAD4452F3}" dt="2021-09-27T20:47:56.473" v="6451" actId="1076"/>
          <ac:spMkLst>
            <pc:docMk/>
            <pc:sldMk cId="954159042" sldId="257"/>
            <ac:spMk id="199" creationId="{49CA2C6B-0F24-4F84-BC63-55C6DC0DDE95}"/>
          </ac:spMkLst>
        </pc:spChg>
        <pc:spChg chg="add del mod">
          <ac:chgData name="Lois Hoyer" userId="8c378a1a5b622d94" providerId="LiveId" clId="{78389128-E705-4C11-AC5D-CFDCAD4452F3}" dt="2021-09-20T18:02:47.557" v="3422" actId="21"/>
          <ac:spMkLst>
            <pc:docMk/>
            <pc:sldMk cId="954159042" sldId="257"/>
            <ac:spMk id="200" creationId="{7195591E-BBD2-4451-BA5A-74E462FA09D1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200" creationId="{BAC4B426-8CB9-F94F-8ED7-CFBA3617F72C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201" creationId="{88F1D954-12FF-0845-987E-A6C951E22953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202" creationId="{BDA7CF03-9241-A840-A6DD-A25FD08E4A2E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203" creationId="{75AE0D25-17EB-FB4F-93AA-77C6F7EC4325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204" creationId="{FEA841B3-43D7-FC42-9278-7D2E854AFC14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205" creationId="{13B0B2E0-EA5C-0946-9D17-9798535E8A40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206" creationId="{2DABDFAF-4A4E-F648-A187-42BE32B71F51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207" creationId="{3C1E6975-E941-6443-872A-6B87291F9BDB}"/>
          </ac:spMkLst>
        </pc:spChg>
        <pc:spChg chg="del mod topLvl">
          <ac:chgData name="Lois Hoyer" userId="8c378a1a5b622d94" providerId="LiveId" clId="{78389128-E705-4C11-AC5D-CFDCAD4452F3}" dt="2021-09-03T20:52:47.995" v="1430" actId="478"/>
          <ac:spMkLst>
            <pc:docMk/>
            <pc:sldMk cId="954159042" sldId="257"/>
            <ac:spMk id="208" creationId="{8B3E10D9-3AA1-A84D-AF8C-8AED47BCB266}"/>
          </ac:spMkLst>
        </pc:spChg>
        <pc:spChg chg="del mod topLvl">
          <ac:chgData name="Lois Hoyer" userId="8c378a1a5b622d94" providerId="LiveId" clId="{78389128-E705-4C11-AC5D-CFDCAD4452F3}" dt="2021-09-03T20:50:12.644" v="1371" actId="478"/>
          <ac:spMkLst>
            <pc:docMk/>
            <pc:sldMk cId="954159042" sldId="257"/>
            <ac:spMk id="209" creationId="{51016769-AF00-9149-ABB2-AB801F073387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210" creationId="{CB809839-FBA7-A34A-889F-6C81E2B50E62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211" creationId="{6EC4AA36-0010-124D-9947-18E3D87900FC}"/>
          </ac:spMkLst>
        </pc:spChg>
        <pc:spChg chg="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13" creationId="{85D82ECA-64C8-364E-B94A-3E9EB2090B81}"/>
          </ac:spMkLst>
        </pc:spChg>
        <pc:spChg chg="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14" creationId="{BB3B86EC-4D9B-2D4D-8275-021DC2AE36F2}"/>
          </ac:spMkLst>
        </pc:spChg>
        <pc:spChg chg="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15" creationId="{F8A78A56-44C0-1543-B7BB-40FC448D493A}"/>
          </ac:spMkLst>
        </pc:spChg>
        <pc:spChg chg="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16" creationId="{19E874DD-9764-0042-BE1A-3A732A05C200}"/>
          </ac:spMkLst>
        </pc:spChg>
        <pc:spChg chg="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17" creationId="{575FE7AE-1F2C-AD42-81C0-990EA16BD30A}"/>
          </ac:spMkLst>
        </pc:spChg>
        <pc:spChg chg="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18" creationId="{61471033-8ADD-AE47-942B-7255AC6C78CE}"/>
          </ac:spMkLst>
        </pc:spChg>
        <pc:spChg chg="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19" creationId="{508E4FDC-86FD-3841-8F25-E5C77E3BD5C2}"/>
          </ac:spMkLst>
        </pc:spChg>
        <pc:spChg chg="del mod topLvl">
          <ac:chgData name="Lois Hoyer" userId="8c378a1a5b622d94" providerId="LiveId" clId="{78389128-E705-4C11-AC5D-CFDCAD4452F3}" dt="2021-09-03T21:27:27.818" v="1628" actId="478"/>
          <ac:spMkLst>
            <pc:docMk/>
            <pc:sldMk cId="954159042" sldId="257"/>
            <ac:spMk id="220" creationId="{1CD43185-18AF-F54C-A379-C13E28EA963F}"/>
          </ac:spMkLst>
        </pc:spChg>
        <pc:spChg chg="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21" creationId="{4FFF5BFC-BE96-AA46-AFE3-89F16477E32D}"/>
          </ac:spMkLst>
        </pc:spChg>
        <pc:spChg chg="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22" creationId="{9BC578EC-8622-FB44-A5AC-C9170AC276CE}"/>
          </ac:spMkLst>
        </pc:spChg>
        <pc:spChg chg="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23" creationId="{F65B413F-95AC-7443-B13B-471F96D74DFE}"/>
          </ac:spMkLst>
        </pc:spChg>
        <pc:spChg chg="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24" creationId="{C07241EF-8DD4-FF44-8F99-E9CE27F1A3A8}"/>
          </ac:spMkLst>
        </pc:spChg>
        <pc:spChg chg="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25" creationId="{D7BCF7AB-F974-6E4C-9E21-9F49BE335C79}"/>
          </ac:spMkLst>
        </pc:spChg>
        <pc:spChg chg="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26" creationId="{76565A3D-9FD9-5147-95F0-756FB4CF198F}"/>
          </ac:spMkLst>
        </pc:spChg>
        <pc:spChg chg="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27" creationId="{D3AEA6F3-0062-8248-9A53-95D7E2B3A3E2}"/>
          </ac:spMkLst>
        </pc:spChg>
        <pc:spChg chg="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28" creationId="{6203B029-4A67-7241-9A4B-9EC4EA617B98}"/>
          </ac:spMkLst>
        </pc:spChg>
        <pc:spChg chg="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29" creationId="{16676433-C7D9-7B4C-A42E-7F6A4E28D745}"/>
          </ac:spMkLst>
        </pc:spChg>
        <pc:spChg chg="del mod topLvl">
          <ac:chgData name="Lois Hoyer" userId="8c378a1a5b622d94" providerId="LiveId" clId="{78389128-E705-4C11-AC5D-CFDCAD4452F3}" dt="2021-09-03T21:27:26.615" v="1627" actId="478"/>
          <ac:spMkLst>
            <pc:docMk/>
            <pc:sldMk cId="954159042" sldId="257"/>
            <ac:spMk id="230" creationId="{8F5FDF49-CDD7-9F4E-B9E7-E9805977E4E8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231" creationId="{1E4C1F27-3CF2-467C-BDE5-42943CE89A2A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232" creationId="{5714C15C-920D-A44B-AFC5-6FBA20766FD8}"/>
          </ac:spMkLst>
        </pc:spChg>
        <pc:spChg chg="add mod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233" creationId="{77C747A9-A8F1-4F14-B8C1-5E5AD8AC42AF}"/>
          </ac:spMkLst>
        </pc:spChg>
        <pc:spChg chg="del mod topLvl">
          <ac:chgData name="Lois Hoyer" userId="8c378a1a5b622d94" providerId="LiveId" clId="{78389128-E705-4C11-AC5D-CFDCAD4452F3}" dt="2021-09-02T22:02:51.099" v="874" actId="478"/>
          <ac:spMkLst>
            <pc:docMk/>
            <pc:sldMk cId="954159042" sldId="257"/>
            <ac:spMk id="233" creationId="{B71E76C7-CB75-1044-8EB6-D3552773A2E5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234" creationId="{AF3BE8F0-B102-1B43-9351-8D93E5A7A09E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235" creationId="{8C7D9870-0076-9340-B162-9902FD580602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236" creationId="{F3817876-8F7E-4EF4-B356-16F977988B20}"/>
          </ac:spMkLst>
        </pc:spChg>
        <pc:spChg chg="add mod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237" creationId="{54F172E1-494E-4D68-94BB-712DA84C81FD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37" creationId="{9C70A6B7-1F0C-5742-9742-950F22DD37AF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38" creationId="{99537C7D-5062-4049-8D27-99736892554F}"/>
          </ac:spMkLst>
        </pc:spChg>
        <pc:spChg chg="add mod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238" creationId="{9AB41F77-939E-4965-843E-95958C04A1CD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39" creationId="{5A6CED0B-3625-40D3-AA02-ABB7470015DF}"/>
          </ac:spMkLst>
        </pc:spChg>
        <pc:spChg chg="add 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40" creationId="{073A4B16-39B1-489F-B00C-587B721C8A51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40" creationId="{FE434426-F5A5-8249-8C5F-8F46B329CD1E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41" creationId="{2B18DD88-7C18-E94D-9772-A69D9A78BA97}"/>
          </ac:spMkLst>
        </pc:spChg>
        <pc:spChg chg="add 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41" creationId="{A40330A8-4FCC-431A-A81F-B1F60E0C292B}"/>
          </ac:spMkLst>
        </pc:spChg>
        <pc:spChg chg="add mod topLvl">
          <ac:chgData name="Lois Hoyer" userId="8c378a1a5b622d94" providerId="LiveId" clId="{78389128-E705-4C11-AC5D-CFDCAD4452F3}" dt="2021-09-16T16:21:51.500" v="3294" actId="164"/>
          <ac:spMkLst>
            <pc:docMk/>
            <pc:sldMk cId="954159042" sldId="257"/>
            <ac:spMk id="242" creationId="{502A29FB-28D0-48B7-BD02-1F84F61D5F6D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42" creationId="{5B67FA09-4B92-A348-9751-0D9B58166A87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43" creationId="{15A2421F-3CE1-6442-8D74-C0F00A7BCA9E}"/>
          </ac:spMkLst>
        </pc:spChg>
        <pc:spChg chg="add mod topLvl">
          <ac:chgData name="Lois Hoyer" userId="8c378a1a5b622d94" providerId="LiveId" clId="{78389128-E705-4C11-AC5D-CFDCAD4452F3}" dt="2021-09-16T16:22:06.416" v="3296" actId="20577"/>
          <ac:spMkLst>
            <pc:docMk/>
            <pc:sldMk cId="954159042" sldId="257"/>
            <ac:spMk id="243" creationId="{59B690FB-28A0-48DC-9E55-4CF5CDD13557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44" creationId="{236EFF94-6FF9-FD44-BA03-135283C21D41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45" creationId="{2C80DEA9-A087-D14E-A041-2647DB44993E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46" creationId="{55ACFE85-9EE0-CC4A-847F-00AC21F16E60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47" creationId="{BEA6DD24-A8BB-544A-9751-A204273BCF6F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48" creationId="{18ED6190-51AF-F942-BABE-6A330BD7FAB0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49" creationId="{D8B08930-739D-1E47-B0B7-0D17A2A0FF0A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50" creationId="{EE268243-8AF4-5E4A-B046-1885A1F47F2E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51" creationId="{2C730969-51A3-7149-8677-52544A3304E1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52" creationId="{F7D44CB5-2F7B-5A4E-ABD7-BA5DB9361FEB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53" creationId="{99E76684-74BD-674C-B50C-D374CE4F8B0B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54" creationId="{1E5BFE5D-08C7-0E46-ADE8-764BA427C43E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55" creationId="{89B5B30F-5F76-F048-BD78-15D9A279F953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56" creationId="{B537BE2F-18A4-7A4B-9829-3F5CD15CC2A0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57" creationId="{DB161A0D-CFF3-B548-AE99-E3638E503B05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58" creationId="{19162147-B251-8543-8FF1-BD285B7CB61E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59" creationId="{0565DCF4-F9D7-8947-A620-5EC19D694A70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60" creationId="{40ACDC38-96F6-1248-A755-6AB6B165FDDC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61" creationId="{E9627371-3047-9D4A-B70A-E6C780435FAB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62" creationId="{EB2F0DF1-0040-4A4B-93B5-49E632CFC1FB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63" creationId="{CDA332E9-47E3-0343-9479-41BC313F56FA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64" creationId="{1CE82F89-EBBE-E04C-A0F0-8EBCD75417F2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65" creationId="{8E9828C9-6E36-FF4C-88CF-F1C2C823358E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66" creationId="{F14E29AB-94FE-E346-B986-445555ACA88A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67" creationId="{1C6F5E3D-72D6-9B43-A26F-FBDD009C9090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68" creationId="{D6F54485-BE22-954A-AB3D-1E3D5F6B07FD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69" creationId="{1DBFCB14-939B-3140-BECA-E8BB735FDE27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70" creationId="{A644BF4A-7EC7-B740-901E-2111C0345421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71" creationId="{0345A00B-13CC-2F43-9C8E-7FCA88C5DFBC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72" creationId="{2D30B496-9157-8A4D-9175-D0272833C251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73" creationId="{D85F3178-88D0-3643-BE27-5FDABC58152C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74" creationId="{CF3E8D10-6DD0-0448-BEA2-203887FFDEB8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75" creationId="{03F85601-8BCB-2F4B-89D1-B236F44EC378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76" creationId="{3AC7E3CA-5F7D-7949-B0E1-3BFFAF97706D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77" creationId="{A32E2152-0A2D-DE4E-ACCE-6D3DAD835169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78" creationId="{956C1F9C-50B1-D84E-AC35-F6AC44A37EDE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79" creationId="{0C339FA3-555C-DF47-A893-E71A727A7298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80" creationId="{71C076FA-11CA-364C-A884-45D03C74D743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81" creationId="{FA096614-58AE-4744-B74D-3B7B473F2913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82" creationId="{A313726D-6188-5C49-BA03-843C07481E2D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83" creationId="{B8FF7064-28EF-4EA0-B141-3F2F172EB12E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84" creationId="{2DC03E7F-4082-445F-A6A6-6AE9C3889E0B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85" creationId="{265385A2-299C-4E72-87FC-720272202F31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86" creationId="{5E248701-F4E4-4F3C-9510-6982FF409453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87" creationId="{833E0DB3-F7BF-40F9-9CDC-0F2F52339A19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88" creationId="{C57C3920-4B6B-4838-93A8-65AB22133FFD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89" creationId="{2FB0258A-BAED-4FBE-8C4D-C345AA9E5DA4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90" creationId="{A96CF203-B873-4153-8AE3-A9E36F3076EB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91" creationId="{CB459989-0B9C-4D0B-825C-3E60AEF0CF88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92" creationId="{06007B7B-2D0A-495D-8C28-723D8F4D1303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93" creationId="{4693FBB4-0C86-4015-A6EB-CF3B04B56138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94" creationId="{1A2DE2C9-8B54-4E57-B5AE-3F3B1563FF0E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95" creationId="{FAEAB279-9944-4263-808D-681F2FCF70EF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96" creationId="{0B269D57-D581-43F3-8CD2-64B7D160861C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97" creationId="{AA9E77A8-66B5-42F0-99E8-28E8927CDA61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298" creationId="{88CB2FF4-5812-4D2A-8414-424E9D67477A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299" creationId="{38AD0ECD-DA90-D341-B0D1-E821DA334FEE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300" creationId="{266EB614-F7BE-CC45-9A23-EDF95BB37B8E}"/>
          </ac:spMkLst>
        </pc:spChg>
        <pc:spChg chg="mod">
          <ac:chgData name="Lois Hoyer" userId="8c378a1a5b622d94" providerId="LiveId" clId="{78389128-E705-4C11-AC5D-CFDCAD4452F3}" dt="2021-09-02T21:32:22.432" v="480" actId="165"/>
          <ac:spMkLst>
            <pc:docMk/>
            <pc:sldMk cId="954159042" sldId="257"/>
            <ac:spMk id="301" creationId="{28E8E0BF-DBFB-3940-BC32-8675C4B71D6E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02" creationId="{5EBEC098-BEDE-C048-9483-573D0A1F313C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03" creationId="{627671DD-F726-0A4F-A320-3002DFF1AFA8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304" creationId="{C5E5B9CD-E056-46C7-A66D-5D81B3B6A9A9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05" creationId="{B10C6112-FE53-6949-BC57-4E64F37DDB5D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06" creationId="{E5C7510B-3506-FA42-B74C-CC8F9F55524F}"/>
          </ac:spMkLst>
        </pc:spChg>
        <pc:spChg chg="add del 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07" creationId="{5A049BA4-2887-0249-8DA8-5F3BC38C257E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08" creationId="{8BB82904-4718-FE49-9F8F-FE3EBB34C10A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09" creationId="{C2DF8A43-B881-4F4C-B6DA-FCA77B7E3371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10" creationId="{5FC280B9-F952-8842-903F-CDBA2604F3E8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11" creationId="{354D9C5F-C24C-1044-9776-23ABADDCD482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12" creationId="{D56356B0-6A30-4E4E-8704-C2DC6389BB70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13" creationId="{D7011E76-0597-8B43-9DD0-0B47142C96EA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14" creationId="{48017F2D-188A-0542-986D-4D080406614F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15" creationId="{433A6CAD-2286-0C45-88D2-FE54F1C3C205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16" creationId="{8E6EB4D5-40AB-1444-8006-54A1BBBD1C8B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17" creationId="{86AA4E07-573F-C44A-B65A-68B28D3465FE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18" creationId="{8FA4E89F-E150-EB4B-B263-C7846512B56F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19" creationId="{DAE8AB11-7A6D-7541-ADC6-B9BA1723EACE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20" creationId="{C4576AB0-52E5-CB49-BA0A-40CD2811F262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21" creationId="{D1409400-5957-C243-B5DB-E2928B1CE43F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22" creationId="{60057E65-B016-BA4A-A8E4-F4EDD0EC5591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23" creationId="{785E5300-5491-9F4E-BCB0-328CDC070842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24" creationId="{68C084C8-33D9-F242-A85C-F7FC857E1325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25" creationId="{A425EB8C-A8EA-FC41-9190-953902793C39}"/>
          </ac:spMkLst>
        </pc:spChg>
        <pc:spChg chg="del mod topLvl">
          <ac:chgData name="Lois Hoyer" userId="8c378a1a5b622d94" providerId="LiveId" clId="{78389128-E705-4C11-AC5D-CFDCAD4452F3}" dt="2021-09-03T21:19:46.167" v="1541" actId="478"/>
          <ac:spMkLst>
            <pc:docMk/>
            <pc:sldMk cId="954159042" sldId="257"/>
            <ac:spMk id="326" creationId="{4940AEB9-2CC3-544D-956A-43D8CE4E9948}"/>
          </ac:spMkLst>
        </pc:spChg>
        <pc:spChg chg="del mod topLvl">
          <ac:chgData name="Lois Hoyer" userId="8c378a1a5b622d94" providerId="LiveId" clId="{78389128-E705-4C11-AC5D-CFDCAD4452F3}" dt="2021-09-03T21:19:46.167" v="1541" actId="478"/>
          <ac:spMkLst>
            <pc:docMk/>
            <pc:sldMk cId="954159042" sldId="257"/>
            <ac:spMk id="327" creationId="{32719D5A-9799-644D-852B-53AE46CA37B5}"/>
          </ac:spMkLst>
        </pc:spChg>
        <pc:spChg chg="del mod topLvl">
          <ac:chgData name="Lois Hoyer" userId="8c378a1a5b622d94" providerId="LiveId" clId="{78389128-E705-4C11-AC5D-CFDCAD4452F3}" dt="2021-09-03T21:19:46.167" v="1541" actId="478"/>
          <ac:spMkLst>
            <pc:docMk/>
            <pc:sldMk cId="954159042" sldId="257"/>
            <ac:spMk id="328" creationId="{9C71777C-2EC4-9943-B08B-6E2FE4F9961B}"/>
          </ac:spMkLst>
        </pc:spChg>
        <pc:spChg chg="del mod topLvl">
          <ac:chgData name="Lois Hoyer" userId="8c378a1a5b622d94" providerId="LiveId" clId="{78389128-E705-4C11-AC5D-CFDCAD4452F3}" dt="2021-09-03T21:19:46.167" v="1541" actId="478"/>
          <ac:spMkLst>
            <pc:docMk/>
            <pc:sldMk cId="954159042" sldId="257"/>
            <ac:spMk id="329" creationId="{114A9C40-C360-7848-A030-AA1B75DFA3EF}"/>
          </ac:spMkLst>
        </pc:spChg>
        <pc:spChg chg="del mod topLvl">
          <ac:chgData name="Lois Hoyer" userId="8c378a1a5b622d94" providerId="LiveId" clId="{78389128-E705-4C11-AC5D-CFDCAD4452F3}" dt="2021-09-03T21:19:46.167" v="1541" actId="478"/>
          <ac:spMkLst>
            <pc:docMk/>
            <pc:sldMk cId="954159042" sldId="257"/>
            <ac:spMk id="330" creationId="{BBAFB8EB-14D4-1C47-9365-690BFDD50F0B}"/>
          </ac:spMkLst>
        </pc:spChg>
        <pc:spChg chg="del mod topLvl">
          <ac:chgData name="Lois Hoyer" userId="8c378a1a5b622d94" providerId="LiveId" clId="{78389128-E705-4C11-AC5D-CFDCAD4452F3}" dt="2021-09-03T21:19:46.167" v="1541" actId="478"/>
          <ac:spMkLst>
            <pc:docMk/>
            <pc:sldMk cId="954159042" sldId="257"/>
            <ac:spMk id="331" creationId="{876863B4-E4B6-024F-B155-9058C843EAB1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332" creationId="{088B3262-7A67-4182-99C3-66720EA4002D}"/>
          </ac:spMkLst>
        </pc:spChg>
        <pc:spChg chg="del mod topLvl">
          <ac:chgData name="Lois Hoyer" userId="8c378a1a5b622d94" providerId="LiveId" clId="{78389128-E705-4C11-AC5D-CFDCAD4452F3}" dt="2021-09-03T20:39:52.439" v="1257" actId="478"/>
          <ac:spMkLst>
            <pc:docMk/>
            <pc:sldMk cId="954159042" sldId="257"/>
            <ac:spMk id="333" creationId="{64B7C1D8-8558-4966-AAFA-614D1E1ED380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34" creationId="{F0915F23-7C1E-4995-8FF0-1CC006EE1324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35" creationId="{45B225F8-567E-489B-A04C-7D62352C35EC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36" creationId="{92A5DFA5-E24D-4757-8843-7F57766B26D6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37" creationId="{D4434F1C-13DD-455A-91FC-3AB67C08CEA3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38" creationId="{3B978BF6-E559-42CB-955E-8217D3B26E41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39" creationId="{7EBF37DE-719F-45F3-9A60-98560C007AFC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40" creationId="{BAE205B8-756D-48FD-8EF8-67E614B77FC1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41" creationId="{8434C968-14F8-4784-9A07-A50614B537B9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42" creationId="{FD9F3A7E-D6A7-4707-9339-848D8ADC77A6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43" creationId="{40846269-1A94-4A9A-85AA-9059554FCA9A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44" creationId="{678E7486-5043-4845-AA8F-9C943380CEDF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45" creationId="{08AE050C-22EE-47B4-939A-8DA735B3977D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46" creationId="{0C5E89BC-7E9E-4874-AFBB-20D3870A7104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47" creationId="{4ADF4831-F462-427E-A7FC-58CD43A6E6B5}"/>
          </ac:spMkLst>
        </pc:spChg>
        <pc:spChg chg="del mod topLvl">
          <ac:chgData name="Lois Hoyer" userId="8c378a1a5b622d94" providerId="LiveId" clId="{78389128-E705-4C11-AC5D-CFDCAD4452F3}" dt="2021-09-03T21:22:03.156" v="1543" actId="478"/>
          <ac:spMkLst>
            <pc:docMk/>
            <pc:sldMk cId="954159042" sldId="257"/>
            <ac:spMk id="348" creationId="{1CD75AB0-1594-D74E-82A1-EE7A6941BF69}"/>
          </ac:spMkLst>
        </pc:spChg>
        <pc:spChg chg="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49" creationId="{65C8B04C-49FF-674A-93C4-71C76B8483ED}"/>
          </ac:spMkLst>
        </pc:spChg>
        <pc:spChg chg="del mod topLvl">
          <ac:chgData name="Lois Hoyer" userId="8c378a1a5b622d94" providerId="LiveId" clId="{78389128-E705-4C11-AC5D-CFDCAD4452F3}" dt="2021-09-03T21:22:02.042" v="1542" actId="478"/>
          <ac:spMkLst>
            <pc:docMk/>
            <pc:sldMk cId="954159042" sldId="257"/>
            <ac:spMk id="350" creationId="{031A17F7-7354-384E-8058-00495868DCBB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51" creationId="{6D9B4BFE-05E3-034B-88CB-71335E9B5235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52" creationId="{318195C7-17A0-48EE-97F0-5BD65E2606A5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53" creationId="{69A6DD2A-25E4-0440-ABF2-FC49340CA5BE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54" creationId="{611EF73E-40A3-184E-B41A-F5E1D2E8C16F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55" creationId="{BD38B845-BC09-CB4F-8454-C4B35FA26239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56" creationId="{D646CF31-C5F9-CE40-8F41-4F0C9A747AA9}"/>
          </ac:spMkLst>
        </pc:spChg>
        <pc:spChg chg="mod topLvl">
          <ac:chgData name="Lois Hoyer" userId="8c378a1a5b622d94" providerId="LiveId" clId="{78389128-E705-4C11-AC5D-CFDCAD4452F3}" dt="2021-09-15T19:59:48.250" v="2516" actId="164"/>
          <ac:spMkLst>
            <pc:docMk/>
            <pc:sldMk cId="954159042" sldId="257"/>
            <ac:spMk id="357" creationId="{3C506736-E249-F24C-B004-48C7FC547291}"/>
          </ac:spMkLst>
        </pc:spChg>
        <pc:spChg chg="mod topLvl">
          <ac:chgData name="Lois Hoyer" userId="8c378a1a5b622d94" providerId="LiveId" clId="{78389128-E705-4C11-AC5D-CFDCAD4452F3}" dt="2021-09-15T19:59:48.250" v="2516" actId="164"/>
          <ac:spMkLst>
            <pc:docMk/>
            <pc:sldMk cId="954159042" sldId="257"/>
            <ac:spMk id="358" creationId="{0CC6B486-A6BC-5E47-A566-008FFBBF44A1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59" creationId="{4F488345-D11D-4947-A381-7925D7BAFCC8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60" creationId="{373DAC7E-8969-4011-A04F-C87B2A71163A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61" creationId="{0FCB2C15-C24E-402F-836A-A19478A64D32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62" creationId="{8C640ABD-4B05-43C9-B504-E95C84CDD5D3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63" creationId="{9AA04695-FCFC-460B-8975-F647E107FE48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64" creationId="{083772A3-EFC2-4E82-BA7D-9A37522EBE28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65" creationId="{16EEABCD-6302-4966-B35F-714DA6F1A403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66" creationId="{B7625315-C27F-47F1-AC9F-96CA6EC9EAB7}"/>
          </ac:spMkLst>
        </pc:spChg>
        <pc:spChg chg="del mod topLvl">
          <ac:chgData name="Lois Hoyer" userId="8c378a1a5b622d94" providerId="LiveId" clId="{78389128-E705-4C11-AC5D-CFDCAD4452F3}" dt="2021-09-02T21:32:28.096" v="482" actId="478"/>
          <ac:spMkLst>
            <pc:docMk/>
            <pc:sldMk cId="954159042" sldId="257"/>
            <ac:spMk id="367" creationId="{8DDBC149-17D4-8043-9BA1-5269F971EB96}"/>
          </ac:spMkLst>
        </pc:spChg>
        <pc:spChg chg="del mod topLvl">
          <ac:chgData name="Lois Hoyer" userId="8c378a1a5b622d94" providerId="LiveId" clId="{78389128-E705-4C11-AC5D-CFDCAD4452F3}" dt="2021-09-02T21:32:29.753" v="483" actId="478"/>
          <ac:spMkLst>
            <pc:docMk/>
            <pc:sldMk cId="954159042" sldId="257"/>
            <ac:spMk id="368" creationId="{5DF8F4D0-EB5D-564F-ABFA-7118C9AEFB66}"/>
          </ac:spMkLst>
        </pc:spChg>
        <pc:spChg chg="del mod topLvl">
          <ac:chgData name="Lois Hoyer" userId="8c378a1a5b622d94" providerId="LiveId" clId="{78389128-E705-4C11-AC5D-CFDCAD4452F3}" dt="2021-09-02T21:32:31.736" v="484" actId="478"/>
          <ac:spMkLst>
            <pc:docMk/>
            <pc:sldMk cId="954159042" sldId="257"/>
            <ac:spMk id="369" creationId="{842C41CA-CAA0-944F-BDFB-FC6FCEDA3BED}"/>
          </ac:spMkLst>
        </pc:spChg>
        <pc:spChg chg="del mod topLvl">
          <ac:chgData name="Lois Hoyer" userId="8c378a1a5b622d94" providerId="LiveId" clId="{78389128-E705-4C11-AC5D-CFDCAD4452F3}" dt="2021-09-02T21:32:26.304" v="481" actId="478"/>
          <ac:spMkLst>
            <pc:docMk/>
            <pc:sldMk cId="954159042" sldId="257"/>
            <ac:spMk id="370" creationId="{171A0D39-1074-6045-93DF-F7CD286B07A6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71" creationId="{6B43BCF4-9493-4A1D-A1E3-8FD83DCB7581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72" creationId="{CE54A151-2DD8-4061-8211-2546D0E7EFD3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73" creationId="{9CF14897-40A1-4138-BBE4-C2FAA7E9C260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74" creationId="{C26CF103-1FB0-4F29-99BF-2FDBFB8732CF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75" creationId="{9F77893C-6A18-45BE-BFF1-F393E17C419D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76" creationId="{9EB85A35-A14E-485E-9431-3F33DC81FBBC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77" creationId="{8917CC5F-3CD0-4AB1-A865-E7B68008636F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78" creationId="{CB0C1B7A-DC05-4803-80BB-3577E4C9BC38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79" creationId="{30F8C9C9-32A2-40D9-A0FD-FD2501C6F57D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80" creationId="{6335AE47-4327-45E7-97A2-4DBF9BFE014B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81" creationId="{BF87F909-DD39-45C2-A21A-136452FBE52A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82" creationId="{88C3FA57-A017-488F-8564-3AF2DA2F2046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83" creationId="{DC8E94A4-BFA3-436D-9941-150A3B98CBDB}"/>
          </ac:spMkLst>
        </pc:spChg>
        <pc:spChg chg="del mod topLvl">
          <ac:chgData name="Lois Hoyer" userId="8c378a1a5b622d94" providerId="LiveId" clId="{78389128-E705-4C11-AC5D-CFDCAD4452F3}" dt="2021-09-03T20:40:05.049" v="1285" actId="478"/>
          <ac:spMkLst>
            <pc:docMk/>
            <pc:sldMk cId="954159042" sldId="257"/>
            <ac:spMk id="384" creationId="{E0AFD98D-D690-456A-BDE5-95B906C01897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85" creationId="{3964AB1E-89BB-4939-BB05-809E0962CD26}"/>
          </ac:spMkLst>
        </pc:spChg>
        <pc:spChg chg="del mod topLvl">
          <ac:chgData name="Lois Hoyer" userId="8c378a1a5b622d94" providerId="LiveId" clId="{78389128-E705-4C11-AC5D-CFDCAD4452F3}" dt="2021-09-03T20:42:21.425" v="1337" actId="478"/>
          <ac:spMkLst>
            <pc:docMk/>
            <pc:sldMk cId="954159042" sldId="257"/>
            <ac:spMk id="386" creationId="{99CBA417-C649-4BA6-BF9E-F45735956D32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87" creationId="{76248F1A-938B-48D3-BA05-9A64B6884635}"/>
          </ac:spMkLst>
        </pc:spChg>
        <pc:spChg chg="add 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88" creationId="{57A8A9FC-3736-4388-AAC9-3EC3EDB26837}"/>
          </ac:spMkLst>
        </pc:spChg>
        <pc:spChg chg="add 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89" creationId="{7E9FC659-8FDD-4912-AF2D-8DCF529CAF6E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91" creationId="{F19EA347-FE49-47F2-BC6F-A3A184654115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92" creationId="{ED5C397F-3312-4AF4-8015-3A80C6EFB726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93" creationId="{36168060-76CB-420E-BCAF-19C421ABD4F1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94" creationId="{030D53DE-0990-4136-9E6F-8BF3804EFB90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95" creationId="{C4571992-C1DA-4435-BB43-AAAC2536D9B9}"/>
          </ac:spMkLst>
        </pc:spChg>
        <pc:spChg chg="add mod topLvl">
          <ac:chgData name="Lois Hoyer" userId="8c378a1a5b622d94" providerId="LiveId" clId="{78389128-E705-4C11-AC5D-CFDCAD4452F3}" dt="2021-09-20T18:01:33.657" v="3398" actId="164"/>
          <ac:spMkLst>
            <pc:docMk/>
            <pc:sldMk cId="954159042" sldId="257"/>
            <ac:spMk id="396" creationId="{F189A428-D730-4B4C-AFF8-EDAFEBE104A8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98" creationId="{CEA22B39-CBA2-4004-9BEC-14D30D765765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399" creationId="{C2BC0492-5293-4D21-8387-06B911F61A97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400" creationId="{806AF0C2-1DC8-470A-8B0A-A7B220030E94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401" creationId="{A5FB4058-F611-4540-92B8-8067559024F1}"/>
          </ac:spMkLst>
        </pc:spChg>
        <pc:spChg chg="mod topLvl">
          <ac:chgData name="Lois Hoyer" userId="8c378a1a5b622d94" providerId="LiveId" clId="{78389128-E705-4C11-AC5D-CFDCAD4452F3}" dt="2021-09-15T19:54:55.709" v="2473" actId="165"/>
          <ac:spMkLst>
            <pc:docMk/>
            <pc:sldMk cId="954159042" sldId="257"/>
            <ac:spMk id="402" creationId="{E9A536AF-5123-413F-99D3-31736D04FE0C}"/>
          </ac:spMkLst>
        </pc:spChg>
        <pc:grpChg chg="add mod topLvl">
          <ac:chgData name="Lois Hoyer" userId="8c378a1a5b622d94" providerId="LiveId" clId="{78389128-E705-4C11-AC5D-CFDCAD4452F3}" dt="2021-09-20T18:01:33.657" v="3398" actId="164"/>
          <ac:grpSpMkLst>
            <pc:docMk/>
            <pc:sldMk cId="954159042" sldId="257"/>
            <ac:grpSpMk id="2" creationId="{6EFD2948-55DA-4902-90D1-7CB921835D30}"/>
          </ac:grpSpMkLst>
        </pc:grpChg>
        <pc:grpChg chg="del">
          <ac:chgData name="Lois Hoyer" userId="8c378a1a5b622d94" providerId="LiveId" clId="{78389128-E705-4C11-AC5D-CFDCAD4452F3}" dt="2021-09-02T21:32:22.432" v="480" actId="165"/>
          <ac:grpSpMkLst>
            <pc:docMk/>
            <pc:sldMk cId="954159042" sldId="257"/>
            <ac:grpSpMk id="2" creationId="{93215A78-1D99-4AD4-88F3-CDF43286A90B}"/>
          </ac:grpSpMkLst>
        </pc:grpChg>
        <pc:grpChg chg="add mod topLvl">
          <ac:chgData name="Lois Hoyer" userId="8c378a1a5b622d94" providerId="LiveId" clId="{78389128-E705-4C11-AC5D-CFDCAD4452F3}" dt="2021-09-20T18:01:33.657" v="3398" actId="164"/>
          <ac:grpSpMkLst>
            <pc:docMk/>
            <pc:sldMk cId="954159042" sldId="257"/>
            <ac:grpSpMk id="3" creationId="{E2CE28E9-FB42-4987-8B89-2102FE64116D}"/>
          </ac:grpSpMkLst>
        </pc:grpChg>
        <pc:grpChg chg="add mod topLvl">
          <ac:chgData name="Lois Hoyer" userId="8c378a1a5b622d94" providerId="LiveId" clId="{78389128-E705-4C11-AC5D-CFDCAD4452F3}" dt="2021-09-20T18:01:33.657" v="3398" actId="164"/>
          <ac:grpSpMkLst>
            <pc:docMk/>
            <pc:sldMk cId="954159042" sldId="257"/>
            <ac:grpSpMk id="4" creationId="{FD75F90D-FC9B-4F77-BD3B-55FE9EC5770F}"/>
          </ac:grpSpMkLst>
        </pc:grpChg>
        <pc:grpChg chg="add mod">
          <ac:chgData name="Lois Hoyer" userId="8c378a1a5b622d94" providerId="LiveId" clId="{78389128-E705-4C11-AC5D-CFDCAD4452F3}" dt="2021-09-20T18:01:33.657" v="3398" actId="164"/>
          <ac:grpSpMkLst>
            <pc:docMk/>
            <pc:sldMk cId="954159042" sldId="257"/>
            <ac:grpSpMk id="6" creationId="{01C886CC-55F5-42F9-B132-71A3CF1CA235}"/>
          </ac:grpSpMkLst>
        </pc:grpChg>
        <pc:grpChg chg="add del mod topLvl">
          <ac:chgData name="Lois Hoyer" userId="8c378a1a5b622d94" providerId="LiveId" clId="{78389128-E705-4C11-AC5D-CFDCAD4452F3}" dt="2021-09-15T19:55:01.714" v="2474" actId="165"/>
          <ac:grpSpMkLst>
            <pc:docMk/>
            <pc:sldMk cId="954159042" sldId="257"/>
            <ac:grpSpMk id="6" creationId="{55BC7266-C290-44B7-ADEF-09D53CB48679}"/>
          </ac:grpSpMkLst>
        </pc:grpChg>
        <pc:grpChg chg="del mod topLvl">
          <ac:chgData name="Lois Hoyer" userId="8c378a1a5b622d94" providerId="LiveId" clId="{78389128-E705-4C11-AC5D-CFDCAD4452F3}" dt="2021-09-02T22:02:51.099" v="874" actId="478"/>
          <ac:grpSpMkLst>
            <pc:docMk/>
            <pc:sldMk cId="954159042" sldId="257"/>
            <ac:grpSpMk id="8" creationId="{2D5F40AC-FC4E-4250-AF35-82EA870C55B4}"/>
          </ac:grpSpMkLst>
        </pc:grpChg>
        <pc:grpChg chg="add del mod">
          <ac:chgData name="Lois Hoyer" userId="8c378a1a5b622d94" providerId="LiveId" clId="{78389128-E705-4C11-AC5D-CFDCAD4452F3}" dt="2021-09-15T19:57:17.591" v="2478" actId="165"/>
          <ac:grpSpMkLst>
            <pc:docMk/>
            <pc:sldMk cId="954159042" sldId="257"/>
            <ac:grpSpMk id="8" creationId="{3F79EB61-E29B-4894-9FBB-B2D7ED6263B0}"/>
          </ac:grpSpMkLst>
        </pc:grpChg>
        <pc:grpChg chg="add mod">
          <ac:chgData name="Lois Hoyer" userId="8c378a1a5b622d94" providerId="LiveId" clId="{78389128-E705-4C11-AC5D-CFDCAD4452F3}" dt="2021-09-27T20:47:41.417" v="6449" actId="1076"/>
          <ac:grpSpMkLst>
            <pc:docMk/>
            <pc:sldMk cId="954159042" sldId="257"/>
            <ac:grpSpMk id="8" creationId="{92DBD8A4-0D4B-4834-A02D-A68B33408D5A}"/>
          </ac:grpSpMkLst>
        </pc:grpChg>
        <pc:grpChg chg="del mod topLvl">
          <ac:chgData name="Lois Hoyer" userId="8c378a1a5b622d94" providerId="LiveId" clId="{78389128-E705-4C11-AC5D-CFDCAD4452F3}" dt="2021-09-03T20:48:46.414" v="1343" actId="165"/>
          <ac:grpSpMkLst>
            <pc:docMk/>
            <pc:sldMk cId="954159042" sldId="257"/>
            <ac:grpSpMk id="9" creationId="{856A77B3-DBC9-4D41-AB60-E029FD6E9383}"/>
          </ac:grpSpMkLst>
        </pc:grpChg>
        <pc:grpChg chg="add del mod">
          <ac:chgData name="Lois Hoyer" userId="8c378a1a5b622d94" providerId="LiveId" clId="{78389128-E705-4C11-AC5D-CFDCAD4452F3}" dt="2021-09-16T16:19:30.288" v="3264" actId="165"/>
          <ac:grpSpMkLst>
            <pc:docMk/>
            <pc:sldMk cId="954159042" sldId="257"/>
            <ac:grpSpMk id="9" creationId="{E2090346-637A-4B19-9354-DD4E9B0BA942}"/>
          </ac:grpSpMkLst>
        </pc:grpChg>
        <pc:grpChg chg="del mod topLvl">
          <ac:chgData name="Lois Hoyer" userId="8c378a1a5b622d94" providerId="LiveId" clId="{78389128-E705-4C11-AC5D-CFDCAD4452F3}" dt="2021-09-03T21:15:26.103" v="1513" actId="165"/>
          <ac:grpSpMkLst>
            <pc:docMk/>
            <pc:sldMk cId="954159042" sldId="257"/>
            <ac:grpSpMk id="10" creationId="{7B2D0E5F-1256-4D60-8799-53E8E4216219}"/>
          </ac:grpSpMkLst>
        </pc:grpChg>
        <pc:grpChg chg="add mod">
          <ac:chgData name="Lois Hoyer" userId="8c378a1a5b622d94" providerId="LiveId" clId="{78389128-E705-4C11-AC5D-CFDCAD4452F3}" dt="2021-09-20T18:01:33.657" v="3398" actId="164"/>
          <ac:grpSpMkLst>
            <pc:docMk/>
            <pc:sldMk cId="954159042" sldId="257"/>
            <ac:grpSpMk id="10" creationId="{9D24E1DB-7D29-4BAB-8768-D33E01902757}"/>
          </ac:grpSpMkLst>
        </pc:grpChg>
        <pc:grpChg chg="add mod topLvl">
          <ac:chgData name="Lois Hoyer" userId="8c378a1a5b622d94" providerId="LiveId" clId="{78389128-E705-4C11-AC5D-CFDCAD4452F3}" dt="2021-09-20T18:01:33.657" v="3398" actId="164"/>
          <ac:grpSpMkLst>
            <pc:docMk/>
            <pc:sldMk cId="954159042" sldId="257"/>
            <ac:grpSpMk id="11" creationId="{1CEC6F3C-A5C6-4B1B-88FC-AA791797D987}"/>
          </ac:grpSpMkLst>
        </pc:grpChg>
        <pc:grpChg chg="del mod topLvl">
          <ac:chgData name="Lois Hoyer" userId="8c378a1a5b622d94" providerId="LiveId" clId="{78389128-E705-4C11-AC5D-CFDCAD4452F3}" dt="2021-09-15T19:59:09.781" v="2510" actId="165"/>
          <ac:grpSpMkLst>
            <pc:docMk/>
            <pc:sldMk cId="954159042" sldId="257"/>
            <ac:grpSpMk id="12" creationId="{C1DD9829-8985-46E3-89F5-4393B178712A}"/>
          </ac:grpSpMkLst>
        </pc:grpChg>
        <pc:grpChg chg="del mod topLvl">
          <ac:chgData name="Lois Hoyer" userId="8c378a1a5b622d94" providerId="LiveId" clId="{78389128-E705-4C11-AC5D-CFDCAD4452F3}" dt="2021-09-03T21:24:29.939" v="1578" actId="165"/>
          <ac:grpSpMkLst>
            <pc:docMk/>
            <pc:sldMk cId="954159042" sldId="257"/>
            <ac:grpSpMk id="13" creationId="{0A2E8ADE-C0E2-41A2-8FCC-64857E530A23}"/>
          </ac:grpSpMkLst>
        </pc:grpChg>
        <pc:grpChg chg="del mod topLvl">
          <ac:chgData name="Lois Hoyer" userId="8c378a1a5b622d94" providerId="LiveId" clId="{78389128-E705-4C11-AC5D-CFDCAD4452F3}" dt="2021-09-03T20:28:49.901" v="1144" actId="165"/>
          <ac:grpSpMkLst>
            <pc:docMk/>
            <pc:sldMk cId="954159042" sldId="257"/>
            <ac:grpSpMk id="14" creationId="{86E6E1F4-323A-41AC-9BBD-F781B3C4D42A}"/>
          </ac:grpSpMkLst>
        </pc:grpChg>
        <pc:grpChg chg="add del mod topLvl">
          <ac:chgData name="Lois Hoyer" userId="8c378a1a5b622d94" providerId="LiveId" clId="{78389128-E705-4C11-AC5D-CFDCAD4452F3}" dt="2021-09-15T19:56:59.232" v="2476" actId="165"/>
          <ac:grpSpMkLst>
            <pc:docMk/>
            <pc:sldMk cId="954159042" sldId="257"/>
            <ac:grpSpMk id="15" creationId="{FA4AEEBF-89F0-4016-9FBF-50D452DC4C4C}"/>
          </ac:grpSpMkLst>
        </pc:grpChg>
        <pc:grpChg chg="add del mod">
          <ac:chgData name="Lois Hoyer" userId="8c378a1a5b622d94" providerId="LiveId" clId="{78389128-E705-4C11-AC5D-CFDCAD4452F3}" dt="2021-09-15T19:54:55.709" v="2473" actId="165"/>
          <ac:grpSpMkLst>
            <pc:docMk/>
            <pc:sldMk cId="954159042" sldId="257"/>
            <ac:grpSpMk id="16" creationId="{55C1D8C4-9CD8-470D-8C2D-4A6BA6CAEEB1}"/>
          </ac:grpSpMkLst>
        </pc:grpChg>
        <pc:grpChg chg="add del mod">
          <ac:chgData name="Lois Hoyer" userId="8c378a1a5b622d94" providerId="LiveId" clId="{78389128-E705-4C11-AC5D-CFDCAD4452F3}" dt="2021-09-03T20:39:08.703" v="1255" actId="165"/>
          <ac:grpSpMkLst>
            <pc:docMk/>
            <pc:sldMk cId="954159042" sldId="257"/>
            <ac:grpSpMk id="212" creationId="{3B97F7A4-CD81-4F41-B05E-51A568CE1CC1}"/>
          </ac:grpSpMkLst>
        </pc:grpChg>
        <pc:grpChg chg="add del mod">
          <ac:chgData name="Lois Hoyer" userId="8c378a1a5b622d94" providerId="LiveId" clId="{78389128-E705-4C11-AC5D-CFDCAD4452F3}" dt="2021-09-03T21:01:59.444" v="1442" actId="165"/>
          <ac:grpSpMkLst>
            <pc:docMk/>
            <pc:sldMk cId="954159042" sldId="257"/>
            <ac:grpSpMk id="390" creationId="{99866F29-B179-4F3F-91DD-7942C6B847D8}"/>
          </ac:grpSpMkLst>
        </pc:grpChg>
        <pc:grpChg chg="add del mod">
          <ac:chgData name="Lois Hoyer" userId="8c378a1a5b622d94" providerId="LiveId" clId="{78389128-E705-4C11-AC5D-CFDCAD4452F3}" dt="2021-09-03T21:10:35.050" v="1472" actId="165"/>
          <ac:grpSpMkLst>
            <pc:docMk/>
            <pc:sldMk cId="954159042" sldId="257"/>
            <ac:grpSpMk id="397" creationId="{99EE8B3F-5A69-4D15-80E1-7C5758B5D263}"/>
          </ac:grpSpMkLst>
        </pc:grpChg>
        <pc:graphicFrameChg chg="del mod modGraphic">
          <ac:chgData name="Lois Hoyer" userId="8c378a1a5b622d94" providerId="LiveId" clId="{78389128-E705-4C11-AC5D-CFDCAD4452F3}" dt="2021-09-15T20:47:41.981" v="2881" actId="21"/>
          <ac:graphicFrameMkLst>
            <pc:docMk/>
            <pc:sldMk cId="954159042" sldId="257"/>
            <ac:graphicFrameMk id="17" creationId="{7FEA7734-0AF1-480F-9C37-94C4B1BF7DAD}"/>
          </ac:graphicFrameMkLst>
        </pc:graphicFrameChg>
        <pc:cxnChg chg="add mod">
          <ac:chgData name="Lois Hoyer" userId="8c378a1a5b622d94" providerId="LiveId" clId="{78389128-E705-4C11-AC5D-CFDCAD4452F3}" dt="2021-09-20T18:01:33.657" v="3398" actId="164"/>
          <ac:cxnSpMkLst>
            <pc:docMk/>
            <pc:sldMk cId="954159042" sldId="257"/>
            <ac:cxnSpMk id="14" creationId="{8784C6D3-0A70-4024-8DBC-FADF9CD33241}"/>
          </ac:cxnSpMkLst>
        </pc:cxnChg>
        <pc:cxnChg chg="add mod">
          <ac:chgData name="Lois Hoyer" userId="8c378a1a5b622d94" providerId="LiveId" clId="{78389128-E705-4C11-AC5D-CFDCAD4452F3}" dt="2021-09-20T18:01:33.657" v="3398" actId="164"/>
          <ac:cxnSpMkLst>
            <pc:docMk/>
            <pc:sldMk cId="954159042" sldId="257"/>
            <ac:cxnSpMk id="198" creationId="{8FEF47BD-4120-4D01-9112-A00D6E324BD0}"/>
          </ac:cxnSpMkLst>
        </pc:cxnChg>
      </pc:sldChg>
      <pc:sldChg chg="addSp delSp modSp new mod">
        <pc:chgData name="Lois Hoyer" userId="8c378a1a5b622d94" providerId="LiveId" clId="{78389128-E705-4C11-AC5D-CFDCAD4452F3}" dt="2021-10-07T21:29:02.537" v="8213" actId="20577"/>
        <pc:sldMkLst>
          <pc:docMk/>
          <pc:sldMk cId="3449610840" sldId="258"/>
        </pc:sldMkLst>
        <pc:spChg chg="del">
          <ac:chgData name="Lois Hoyer" userId="8c378a1a5b622d94" providerId="LiveId" clId="{78389128-E705-4C11-AC5D-CFDCAD4452F3}" dt="2021-09-15T20:47:34.462" v="2880" actId="478"/>
          <ac:spMkLst>
            <pc:docMk/>
            <pc:sldMk cId="3449610840" sldId="258"/>
            <ac:spMk id="2" creationId="{507BE971-237A-4954-ACBD-2B5646D19326}"/>
          </ac:spMkLst>
        </pc:spChg>
        <pc:spChg chg="del">
          <ac:chgData name="Lois Hoyer" userId="8c378a1a5b622d94" providerId="LiveId" clId="{78389128-E705-4C11-AC5D-CFDCAD4452F3}" dt="2021-09-15T20:47:33.674" v="2879" actId="478"/>
          <ac:spMkLst>
            <pc:docMk/>
            <pc:sldMk cId="3449610840" sldId="258"/>
            <ac:spMk id="3" creationId="{EAFC4E8F-7FD1-49E1-9696-2CD668AD291C}"/>
          </ac:spMkLst>
        </pc:spChg>
        <pc:spChg chg="add mod">
          <ac:chgData name="Lois Hoyer" userId="8c378a1a5b622d94" providerId="LiveId" clId="{78389128-E705-4C11-AC5D-CFDCAD4452F3}" dt="2021-10-06T13:11:33.739" v="8173" actId="1036"/>
          <ac:spMkLst>
            <pc:docMk/>
            <pc:sldMk cId="3449610840" sldId="258"/>
            <ac:spMk id="5" creationId="{999552C5-04F0-49F6-80D7-4DE321F726AD}"/>
          </ac:spMkLst>
        </pc:spChg>
        <pc:spChg chg="add mod">
          <ac:chgData name="Lois Hoyer" userId="8c378a1a5b622d94" providerId="LiveId" clId="{78389128-E705-4C11-AC5D-CFDCAD4452F3}" dt="2021-10-07T21:29:02.537" v="8213" actId="20577"/>
          <ac:spMkLst>
            <pc:docMk/>
            <pc:sldMk cId="3449610840" sldId="258"/>
            <ac:spMk id="6" creationId="{EFC9B8D9-D629-4402-9C86-3720CE1C806F}"/>
          </ac:spMkLst>
        </pc:spChg>
        <pc:spChg chg="add mod">
          <ac:chgData name="Lois Hoyer" userId="8c378a1a5b622d94" providerId="LiveId" clId="{78389128-E705-4C11-AC5D-CFDCAD4452F3}" dt="2021-10-06T13:11:33.739" v="8173" actId="1036"/>
          <ac:spMkLst>
            <pc:docMk/>
            <pc:sldMk cId="3449610840" sldId="258"/>
            <ac:spMk id="7" creationId="{493D33A3-CCC9-4F57-AB27-3DC7F76EA916}"/>
          </ac:spMkLst>
        </pc:spChg>
        <pc:graphicFrameChg chg="add mod">
          <ac:chgData name="Lois Hoyer" userId="8c378a1a5b622d94" providerId="LiveId" clId="{78389128-E705-4C11-AC5D-CFDCAD4452F3}" dt="2021-10-06T13:11:33.739" v="8173" actId="1036"/>
          <ac:graphicFrameMkLst>
            <pc:docMk/>
            <pc:sldMk cId="3449610840" sldId="258"/>
            <ac:graphicFrameMk id="4" creationId="{9677165E-6841-4086-94F9-FC05AA5EE77F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4649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89067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414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532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79650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1632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0467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76808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4266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7918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6D20A65-16B9-FA42-B754-C65D9F588E00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007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6D20A65-16B9-FA42-B754-C65D9F588E00}" type="datetimeFigureOut">
              <a:rPr lang="en-US" smtClean="0"/>
              <a:t>10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4790D5-2083-4F41-B8EB-A91E544A5C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53399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3">
            <a:extLst>
              <a:ext uri="{FF2B5EF4-FFF2-40B4-BE49-F238E27FC236}">
                <a16:creationId xmlns:a16="http://schemas.microsoft.com/office/drawing/2014/main" id="{96050657-E3F1-48B8-ACFC-2374102DE33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97566" y="4612558"/>
            <a:ext cx="5841745" cy="1692771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  <a:spAutoFit/>
          </a:bodyPr>
          <a:lstStyle/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en-US" altLang="en-US" sz="1000" b="1" i="0" u="sng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nsensus tandem repeat sequence comparisons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ELG_04272</a:t>
            </a:r>
            <a:r>
              <a:rPr kumimoji="0" lang="en-US" altLang="en-US" sz="10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(36 aa)           </a:t>
            </a:r>
            <a:r>
              <a:rPr lang="en-US" sz="100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Times New Roman" panose="02020603050405020304" pitchFamily="18" charset="0"/>
              </a:rPr>
              <a:t>P_NPT_T_S_FW________T____P___D_V___Y</a:t>
            </a:r>
            <a:endParaRPr kumimoji="0" lang="en-US" altLang="en-US" sz="100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a Consensus (36 aa)       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_N_</a:t>
            </a:r>
            <a:r>
              <a:rPr lang="en-US" altLang="en-US" sz="1000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TVTTT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__</a:t>
            </a:r>
            <a:r>
              <a:rPr lang="en-US" altLang="en-US" sz="1000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WS_S___T_T_T__P__T__V___E</a:t>
            </a:r>
            <a:endParaRPr lang="en-US" altLang="en-US" sz="1000" b="1" dirty="0">
              <a:solidFill>
                <a:srgbClr val="000000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tr Consensus (36 aa)      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__NPT_T_T_________T_T_______TD______</a:t>
            </a: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p/Co/Cm Consensus (36 aa) 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_NPT_T_T__WTG____T_T_T__PG_TD_V_V__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1000" b="1" dirty="0">
              <a:solidFill>
                <a:srgbClr val="000000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000" b="1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eAls734</a:t>
            </a: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 (41 aa)        </a:t>
            </a:r>
            <a:r>
              <a:rPr lang="en-US" sz="1000" dirty="0" err="1">
                <a:solidFill>
                  <a:srgbClr val="000000"/>
                </a:solidFill>
                <a:effectLst/>
                <a:latin typeface="Courier New" panose="02070309020205020404" pitchFamily="49" charset="0"/>
                <a:ea typeface="Calibri" panose="020F0502020204030204" pitchFamily="34" charset="0"/>
                <a:cs typeface="Courier New" panose="02070309020205020404" pitchFamily="49" charset="0"/>
              </a:rPr>
              <a:t>RP_TTMYTTTWTKTNEDGSEETDSGIVTQSDE_L_T_TTFP</a:t>
            </a:r>
            <a:endParaRPr lang="en-US" sz="1000" dirty="0">
              <a:solidFill>
                <a:srgbClr val="000000"/>
              </a:solidFill>
              <a:effectLst/>
              <a:latin typeface="Courier New" panose="02070309020205020404" pitchFamily="49" charset="0"/>
              <a:ea typeface="Calibri" panose="020F0502020204030204" pitchFamily="34" charset="0"/>
              <a:cs typeface="Courier New" panose="02070309020205020404" pitchFamily="49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eAls2716 (41 aa)      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_PFTTEYTTTWT_TDEEGNEVTESGIVSQSDESLTT_TTFP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lang="en-US" altLang="en-US" sz="1000" b="1" dirty="0" err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CmAls2265</a:t>
            </a: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 Cons (42 aa) 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P__T_EYTTTWTTTNSDGSVETDSGIVS_SGSS_TTI_TF_P</a:t>
            </a: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lang="en-US" altLang="en-US" sz="1000" dirty="0">
              <a:solidFill>
                <a:srgbClr val="000000"/>
              </a:solidFill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  <a:p>
            <a:pPr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en-US" sz="1000" b="1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LeAls2716 (44 aa</a:t>
            </a:r>
            <a:r>
              <a:rPr lang="en-US" altLang="en-US" sz="1000" b="1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)        </a:t>
            </a:r>
            <a:r>
              <a:rPr lang="en-US" altLang="en-US" sz="1000" dirty="0">
                <a:solidFill>
                  <a:srgbClr val="000000"/>
                </a:solidFill>
                <a:latin typeface="Courier New" panose="02070309020205020404" pitchFamily="49" charset="0"/>
                <a:ea typeface="Times New Roman" panose="02020603050405020304" pitchFamily="18" charset="0"/>
                <a:cs typeface="Courier New" panose="02070309020205020404" pitchFamily="49" charset="0"/>
              </a:rPr>
              <a:t>GDVTTEYTVTWTRTNEDGSEVTESGIVSKSGDYETTITTFPPSE</a:t>
            </a:r>
            <a:endParaRPr kumimoji="0" lang="en-US" altLang="en-US" sz="1000" i="0" u="none" strike="noStrike" cap="none" normalizeH="0" baseline="0" dirty="0">
              <a:ln>
                <a:noFill/>
              </a:ln>
              <a:solidFill>
                <a:srgbClr val="000000"/>
              </a:solidFill>
              <a:effectLst/>
              <a:latin typeface="Courier New" panose="02070309020205020404" pitchFamily="49" charset="0"/>
              <a:ea typeface="Times New Roman" panose="02020603050405020304" pitchFamily="18" charset="0"/>
              <a:cs typeface="Courier New" panose="02070309020205020404" pitchFamily="49" charset="0"/>
            </a:endParaRPr>
          </a:p>
        </p:txBody>
      </p:sp>
      <p:grpSp>
        <p:nvGrpSpPr>
          <p:cNvPr id="8" name="Group 7">
            <a:extLst>
              <a:ext uri="{FF2B5EF4-FFF2-40B4-BE49-F238E27FC236}">
                <a16:creationId xmlns:a16="http://schemas.microsoft.com/office/drawing/2014/main" id="{92DBD8A4-0D4B-4834-A02D-A68B33408D5A}"/>
              </a:ext>
            </a:extLst>
          </p:cNvPr>
          <p:cNvGrpSpPr/>
          <p:nvPr/>
        </p:nvGrpSpPr>
        <p:grpSpPr>
          <a:xfrm>
            <a:off x="422660" y="795014"/>
            <a:ext cx="8275580" cy="3246899"/>
            <a:chOff x="524435" y="682311"/>
            <a:chExt cx="8275580" cy="3246899"/>
          </a:xfrm>
        </p:grpSpPr>
        <p:grpSp>
          <p:nvGrpSpPr>
            <p:cNvPr id="10" name="Group 9">
              <a:extLst>
                <a:ext uri="{FF2B5EF4-FFF2-40B4-BE49-F238E27FC236}">
                  <a16:creationId xmlns:a16="http://schemas.microsoft.com/office/drawing/2014/main" id="{9D24E1DB-7D29-4BAB-8768-D33E01902757}"/>
                </a:ext>
              </a:extLst>
            </p:cNvPr>
            <p:cNvGrpSpPr/>
            <p:nvPr/>
          </p:nvGrpSpPr>
          <p:grpSpPr>
            <a:xfrm>
              <a:off x="6570215" y="2634675"/>
              <a:ext cx="795203" cy="246221"/>
              <a:chOff x="6480044" y="2757786"/>
              <a:chExt cx="795203" cy="246221"/>
            </a:xfrm>
          </p:grpSpPr>
          <p:sp>
            <p:nvSpPr>
              <p:cNvPr id="357" name="Rectangle 356">
                <a:extLst>
                  <a:ext uri="{FF2B5EF4-FFF2-40B4-BE49-F238E27FC236}">
                    <a16:creationId xmlns:a16="http://schemas.microsoft.com/office/drawing/2014/main" id="{3C506736-E249-F24C-B004-48C7FC547291}"/>
                  </a:ext>
                </a:extLst>
              </p:cNvPr>
              <p:cNvSpPr/>
              <p:nvPr/>
            </p:nvSpPr>
            <p:spPr>
              <a:xfrm>
                <a:off x="6480044" y="2762024"/>
                <a:ext cx="237744" cy="237744"/>
              </a:xfrm>
              <a:prstGeom prst="rect">
                <a:avLst/>
              </a:prstGeom>
              <a:solidFill>
                <a:schemeClr val="tx1"/>
              </a:solidFill>
              <a:ln w="3175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/>
              </a:p>
            </p:txBody>
          </p:sp>
          <p:sp>
            <p:nvSpPr>
              <p:cNvPr id="358" name="TextBox 357">
                <a:extLst>
                  <a:ext uri="{FF2B5EF4-FFF2-40B4-BE49-F238E27FC236}">
                    <a16:creationId xmlns:a16="http://schemas.microsoft.com/office/drawing/2014/main" id="{0CC6B486-A6BC-5E47-A566-008FFBBF44A1}"/>
                  </a:ext>
                </a:extLst>
              </p:cNvPr>
              <p:cNvSpPr txBox="1"/>
              <p:nvPr/>
            </p:nvSpPr>
            <p:spPr>
              <a:xfrm>
                <a:off x="6702654" y="2757786"/>
                <a:ext cx="572593" cy="246221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 aa</a:t>
                </a:r>
              </a:p>
            </p:txBody>
          </p:sp>
        </p:grpSp>
        <p:sp>
          <p:nvSpPr>
            <p:cNvPr id="150" name="Rectangle 149">
              <a:extLst>
                <a:ext uri="{FF2B5EF4-FFF2-40B4-BE49-F238E27FC236}">
                  <a16:creationId xmlns:a16="http://schemas.microsoft.com/office/drawing/2014/main" id="{E47BDEE6-1FED-354C-866D-1150E855C0DE}"/>
                </a:ext>
              </a:extLst>
            </p:cNvPr>
            <p:cNvSpPr/>
            <p:nvPr/>
          </p:nvSpPr>
          <p:spPr>
            <a:xfrm>
              <a:off x="622524" y="1832043"/>
              <a:ext cx="36576" cy="228600"/>
            </a:xfrm>
            <a:prstGeom prst="rect">
              <a:avLst/>
            </a:prstGeom>
            <a:solidFill>
              <a:srgbClr val="FF7E79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1" name="Rectangle 150">
              <a:extLst>
                <a:ext uri="{FF2B5EF4-FFF2-40B4-BE49-F238E27FC236}">
                  <a16:creationId xmlns:a16="http://schemas.microsoft.com/office/drawing/2014/main" id="{14088EE7-0D0C-B346-86D2-8863D17A2FAD}"/>
                </a:ext>
              </a:extLst>
            </p:cNvPr>
            <p:cNvSpPr/>
            <p:nvPr/>
          </p:nvSpPr>
          <p:spPr>
            <a:xfrm>
              <a:off x="658633" y="1832043"/>
              <a:ext cx="1005840" cy="228600"/>
            </a:xfrm>
            <a:prstGeom prst="rect">
              <a:avLst/>
            </a:prstGeom>
            <a:solidFill>
              <a:srgbClr val="FF2600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7" name="Rectangle 156">
              <a:extLst>
                <a:ext uri="{FF2B5EF4-FFF2-40B4-BE49-F238E27FC236}">
                  <a16:creationId xmlns:a16="http://schemas.microsoft.com/office/drawing/2014/main" id="{1ACF17DA-E09B-E641-B111-30EE388C3FC2}"/>
                </a:ext>
              </a:extLst>
            </p:cNvPr>
            <p:cNvSpPr/>
            <p:nvPr/>
          </p:nvSpPr>
          <p:spPr>
            <a:xfrm>
              <a:off x="1661804" y="1832043"/>
              <a:ext cx="100584" cy="228600"/>
            </a:xfrm>
            <a:prstGeom prst="rect">
              <a:avLst/>
            </a:prstGeom>
            <a:solidFill>
              <a:srgbClr val="33CC3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8" name="Rectangle 157">
              <a:extLst>
                <a:ext uri="{FF2B5EF4-FFF2-40B4-BE49-F238E27FC236}">
                  <a16:creationId xmlns:a16="http://schemas.microsoft.com/office/drawing/2014/main" id="{E15071A5-0F03-6A46-9E8B-00829A46CDBB}"/>
                </a:ext>
              </a:extLst>
            </p:cNvPr>
            <p:cNvSpPr/>
            <p:nvPr/>
          </p:nvSpPr>
          <p:spPr>
            <a:xfrm>
              <a:off x="1757054" y="1832043"/>
              <a:ext cx="100584" cy="228600"/>
            </a:xfrm>
            <a:prstGeom prst="rect">
              <a:avLst/>
            </a:prstGeom>
            <a:solidFill>
              <a:srgbClr val="33CC3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9" name="Rectangle 158">
              <a:extLst>
                <a:ext uri="{FF2B5EF4-FFF2-40B4-BE49-F238E27FC236}">
                  <a16:creationId xmlns:a16="http://schemas.microsoft.com/office/drawing/2014/main" id="{6BA96F28-2A22-6D42-9CEE-A6DB0C38B0C9}"/>
                </a:ext>
              </a:extLst>
            </p:cNvPr>
            <p:cNvSpPr/>
            <p:nvPr/>
          </p:nvSpPr>
          <p:spPr>
            <a:xfrm>
              <a:off x="1852304" y="1832043"/>
              <a:ext cx="100584" cy="228600"/>
            </a:xfrm>
            <a:prstGeom prst="rect">
              <a:avLst/>
            </a:prstGeom>
            <a:solidFill>
              <a:srgbClr val="33CC3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0" name="Rectangle 159">
              <a:extLst>
                <a:ext uri="{FF2B5EF4-FFF2-40B4-BE49-F238E27FC236}">
                  <a16:creationId xmlns:a16="http://schemas.microsoft.com/office/drawing/2014/main" id="{C3E76E26-5C7D-8848-BB46-5B2E530DCD5C}"/>
                </a:ext>
              </a:extLst>
            </p:cNvPr>
            <p:cNvSpPr/>
            <p:nvPr/>
          </p:nvSpPr>
          <p:spPr>
            <a:xfrm>
              <a:off x="1947554" y="1832043"/>
              <a:ext cx="100584" cy="228600"/>
            </a:xfrm>
            <a:prstGeom prst="rect">
              <a:avLst/>
            </a:prstGeom>
            <a:solidFill>
              <a:srgbClr val="33CC3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1" name="Rectangle 160">
              <a:extLst>
                <a:ext uri="{FF2B5EF4-FFF2-40B4-BE49-F238E27FC236}">
                  <a16:creationId xmlns:a16="http://schemas.microsoft.com/office/drawing/2014/main" id="{F8424D00-05B6-CE4F-BCCE-16CDED4530AE}"/>
                </a:ext>
              </a:extLst>
            </p:cNvPr>
            <p:cNvSpPr/>
            <p:nvPr/>
          </p:nvSpPr>
          <p:spPr>
            <a:xfrm>
              <a:off x="2042804" y="1832043"/>
              <a:ext cx="100584" cy="228600"/>
            </a:xfrm>
            <a:prstGeom prst="rect">
              <a:avLst/>
            </a:prstGeom>
            <a:solidFill>
              <a:srgbClr val="33CC3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2" name="Rectangle 161">
              <a:extLst>
                <a:ext uri="{FF2B5EF4-FFF2-40B4-BE49-F238E27FC236}">
                  <a16:creationId xmlns:a16="http://schemas.microsoft.com/office/drawing/2014/main" id="{87365F4B-0ABB-6343-B0D6-265F7334B295}"/>
                </a:ext>
              </a:extLst>
            </p:cNvPr>
            <p:cNvSpPr/>
            <p:nvPr/>
          </p:nvSpPr>
          <p:spPr>
            <a:xfrm>
              <a:off x="2138054" y="1832043"/>
              <a:ext cx="100584" cy="228600"/>
            </a:xfrm>
            <a:prstGeom prst="rect">
              <a:avLst/>
            </a:prstGeom>
            <a:solidFill>
              <a:srgbClr val="33CC3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3" name="Rectangle 162">
              <a:extLst>
                <a:ext uri="{FF2B5EF4-FFF2-40B4-BE49-F238E27FC236}">
                  <a16:creationId xmlns:a16="http://schemas.microsoft.com/office/drawing/2014/main" id="{91FB8AE8-D5D2-B64A-9C0A-0E8093679156}"/>
                </a:ext>
              </a:extLst>
            </p:cNvPr>
            <p:cNvSpPr/>
            <p:nvPr/>
          </p:nvSpPr>
          <p:spPr>
            <a:xfrm>
              <a:off x="2233304" y="1832043"/>
              <a:ext cx="100584" cy="228600"/>
            </a:xfrm>
            <a:prstGeom prst="rect">
              <a:avLst/>
            </a:prstGeom>
            <a:solidFill>
              <a:srgbClr val="33CC3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4" name="Rectangle 163">
              <a:extLst>
                <a:ext uri="{FF2B5EF4-FFF2-40B4-BE49-F238E27FC236}">
                  <a16:creationId xmlns:a16="http://schemas.microsoft.com/office/drawing/2014/main" id="{E8F7B4BB-5EEB-0B4A-8588-DCC29A320CB8}"/>
                </a:ext>
              </a:extLst>
            </p:cNvPr>
            <p:cNvSpPr/>
            <p:nvPr/>
          </p:nvSpPr>
          <p:spPr>
            <a:xfrm>
              <a:off x="2336094" y="1832043"/>
              <a:ext cx="109728" cy="228600"/>
            </a:xfrm>
            <a:prstGeom prst="rect">
              <a:avLst/>
            </a:prstGeom>
            <a:solidFill>
              <a:srgbClr val="33993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5" name="Rectangle 164">
              <a:extLst>
                <a:ext uri="{FF2B5EF4-FFF2-40B4-BE49-F238E27FC236}">
                  <a16:creationId xmlns:a16="http://schemas.microsoft.com/office/drawing/2014/main" id="{051839E9-0386-AB42-A6DF-A5A17026A531}"/>
                </a:ext>
              </a:extLst>
            </p:cNvPr>
            <p:cNvSpPr/>
            <p:nvPr/>
          </p:nvSpPr>
          <p:spPr>
            <a:xfrm>
              <a:off x="2431344" y="1832043"/>
              <a:ext cx="109728" cy="228600"/>
            </a:xfrm>
            <a:prstGeom prst="rect">
              <a:avLst/>
            </a:prstGeom>
            <a:solidFill>
              <a:srgbClr val="33993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6" name="Rectangle 165">
              <a:extLst>
                <a:ext uri="{FF2B5EF4-FFF2-40B4-BE49-F238E27FC236}">
                  <a16:creationId xmlns:a16="http://schemas.microsoft.com/office/drawing/2014/main" id="{026A5C82-0419-5140-AAA6-563DADFED43E}"/>
                </a:ext>
              </a:extLst>
            </p:cNvPr>
            <p:cNvSpPr/>
            <p:nvPr/>
          </p:nvSpPr>
          <p:spPr>
            <a:xfrm>
              <a:off x="2526594" y="1832043"/>
              <a:ext cx="109728" cy="228600"/>
            </a:xfrm>
            <a:prstGeom prst="rect">
              <a:avLst/>
            </a:prstGeom>
            <a:solidFill>
              <a:srgbClr val="33993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7" name="Rectangle 166">
              <a:extLst>
                <a:ext uri="{FF2B5EF4-FFF2-40B4-BE49-F238E27FC236}">
                  <a16:creationId xmlns:a16="http://schemas.microsoft.com/office/drawing/2014/main" id="{C6435C8B-93BE-384F-A1A6-03657E6953DB}"/>
                </a:ext>
              </a:extLst>
            </p:cNvPr>
            <p:cNvSpPr/>
            <p:nvPr/>
          </p:nvSpPr>
          <p:spPr>
            <a:xfrm>
              <a:off x="2638556" y="1832043"/>
              <a:ext cx="27432" cy="228600"/>
            </a:xfrm>
            <a:prstGeom prst="rect">
              <a:avLst/>
            </a:prstGeom>
            <a:solidFill>
              <a:srgbClr val="339933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8" name="Rectangle 167">
              <a:extLst>
                <a:ext uri="{FF2B5EF4-FFF2-40B4-BE49-F238E27FC236}">
                  <a16:creationId xmlns:a16="http://schemas.microsoft.com/office/drawing/2014/main" id="{EF2D7DF4-DFCB-7443-990E-C5D741AB09AA}"/>
                </a:ext>
              </a:extLst>
            </p:cNvPr>
            <p:cNvSpPr/>
            <p:nvPr/>
          </p:nvSpPr>
          <p:spPr>
            <a:xfrm>
              <a:off x="2663873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69" name="Rectangle 168">
              <a:extLst>
                <a:ext uri="{FF2B5EF4-FFF2-40B4-BE49-F238E27FC236}">
                  <a16:creationId xmlns:a16="http://schemas.microsoft.com/office/drawing/2014/main" id="{181A803C-FAEE-CF40-B340-31C4EE31B1B5}"/>
                </a:ext>
              </a:extLst>
            </p:cNvPr>
            <p:cNvSpPr/>
            <p:nvPr/>
          </p:nvSpPr>
          <p:spPr>
            <a:xfrm>
              <a:off x="2759123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0" name="Rectangle 169">
              <a:extLst>
                <a:ext uri="{FF2B5EF4-FFF2-40B4-BE49-F238E27FC236}">
                  <a16:creationId xmlns:a16="http://schemas.microsoft.com/office/drawing/2014/main" id="{C9EF19B0-B46A-5C47-9035-E6B9A0C2B353}"/>
                </a:ext>
              </a:extLst>
            </p:cNvPr>
            <p:cNvSpPr/>
            <p:nvPr/>
          </p:nvSpPr>
          <p:spPr>
            <a:xfrm>
              <a:off x="2854373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1" name="Rectangle 170">
              <a:extLst>
                <a:ext uri="{FF2B5EF4-FFF2-40B4-BE49-F238E27FC236}">
                  <a16:creationId xmlns:a16="http://schemas.microsoft.com/office/drawing/2014/main" id="{81A37607-0604-354D-9EE2-84C9FC55B924}"/>
                </a:ext>
              </a:extLst>
            </p:cNvPr>
            <p:cNvSpPr/>
            <p:nvPr/>
          </p:nvSpPr>
          <p:spPr>
            <a:xfrm>
              <a:off x="2949623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2" name="Rectangle 171">
              <a:extLst>
                <a:ext uri="{FF2B5EF4-FFF2-40B4-BE49-F238E27FC236}">
                  <a16:creationId xmlns:a16="http://schemas.microsoft.com/office/drawing/2014/main" id="{A80B244B-D767-374D-9E0D-BD4F4B2B6A85}"/>
                </a:ext>
              </a:extLst>
            </p:cNvPr>
            <p:cNvSpPr/>
            <p:nvPr/>
          </p:nvSpPr>
          <p:spPr>
            <a:xfrm>
              <a:off x="3044873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3" name="Rectangle 172">
              <a:extLst>
                <a:ext uri="{FF2B5EF4-FFF2-40B4-BE49-F238E27FC236}">
                  <a16:creationId xmlns:a16="http://schemas.microsoft.com/office/drawing/2014/main" id="{921C9BD1-E966-BB4F-897B-2E23C26268EF}"/>
                </a:ext>
              </a:extLst>
            </p:cNvPr>
            <p:cNvSpPr/>
            <p:nvPr/>
          </p:nvSpPr>
          <p:spPr>
            <a:xfrm>
              <a:off x="3140123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4" name="Rectangle 173">
              <a:extLst>
                <a:ext uri="{FF2B5EF4-FFF2-40B4-BE49-F238E27FC236}">
                  <a16:creationId xmlns:a16="http://schemas.microsoft.com/office/drawing/2014/main" id="{B7A2C6DD-64F5-924B-8A11-559C1FF54F24}"/>
                </a:ext>
              </a:extLst>
            </p:cNvPr>
            <p:cNvSpPr/>
            <p:nvPr/>
          </p:nvSpPr>
          <p:spPr>
            <a:xfrm>
              <a:off x="3235373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5" name="Rectangle 174">
              <a:extLst>
                <a:ext uri="{FF2B5EF4-FFF2-40B4-BE49-F238E27FC236}">
                  <a16:creationId xmlns:a16="http://schemas.microsoft.com/office/drawing/2014/main" id="{CC637010-7190-5D43-9861-9FE9C0B9C637}"/>
                </a:ext>
              </a:extLst>
            </p:cNvPr>
            <p:cNvSpPr/>
            <p:nvPr/>
          </p:nvSpPr>
          <p:spPr>
            <a:xfrm>
              <a:off x="3330623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6" name="Rectangle 175">
              <a:extLst>
                <a:ext uri="{FF2B5EF4-FFF2-40B4-BE49-F238E27FC236}">
                  <a16:creationId xmlns:a16="http://schemas.microsoft.com/office/drawing/2014/main" id="{0F9A79E5-E715-DF46-94B4-283C75FDF5B5}"/>
                </a:ext>
              </a:extLst>
            </p:cNvPr>
            <p:cNvSpPr/>
            <p:nvPr/>
          </p:nvSpPr>
          <p:spPr>
            <a:xfrm>
              <a:off x="3425873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7" name="Rectangle 176">
              <a:extLst>
                <a:ext uri="{FF2B5EF4-FFF2-40B4-BE49-F238E27FC236}">
                  <a16:creationId xmlns:a16="http://schemas.microsoft.com/office/drawing/2014/main" id="{0F308568-0608-434B-A937-766A4389557E}"/>
                </a:ext>
              </a:extLst>
            </p:cNvPr>
            <p:cNvSpPr/>
            <p:nvPr/>
          </p:nvSpPr>
          <p:spPr>
            <a:xfrm>
              <a:off x="3521123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8" name="Rectangle 177">
              <a:extLst>
                <a:ext uri="{FF2B5EF4-FFF2-40B4-BE49-F238E27FC236}">
                  <a16:creationId xmlns:a16="http://schemas.microsoft.com/office/drawing/2014/main" id="{2CCEB257-787F-EA48-8E2C-4B517D5DA5BF}"/>
                </a:ext>
              </a:extLst>
            </p:cNvPr>
            <p:cNvSpPr/>
            <p:nvPr/>
          </p:nvSpPr>
          <p:spPr>
            <a:xfrm>
              <a:off x="3616373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79" name="Rectangle 178">
              <a:extLst>
                <a:ext uri="{FF2B5EF4-FFF2-40B4-BE49-F238E27FC236}">
                  <a16:creationId xmlns:a16="http://schemas.microsoft.com/office/drawing/2014/main" id="{F9F8D19F-6611-A149-9FDB-2AD22ED6FC74}"/>
                </a:ext>
              </a:extLst>
            </p:cNvPr>
            <p:cNvSpPr/>
            <p:nvPr/>
          </p:nvSpPr>
          <p:spPr>
            <a:xfrm>
              <a:off x="3711623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0" name="Rectangle 179">
              <a:extLst>
                <a:ext uri="{FF2B5EF4-FFF2-40B4-BE49-F238E27FC236}">
                  <a16:creationId xmlns:a16="http://schemas.microsoft.com/office/drawing/2014/main" id="{D5554AB5-89C4-334C-8587-63F2EE2EC787}"/>
                </a:ext>
              </a:extLst>
            </p:cNvPr>
            <p:cNvSpPr/>
            <p:nvPr/>
          </p:nvSpPr>
          <p:spPr>
            <a:xfrm>
              <a:off x="3806873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1" name="Rectangle 180">
              <a:extLst>
                <a:ext uri="{FF2B5EF4-FFF2-40B4-BE49-F238E27FC236}">
                  <a16:creationId xmlns:a16="http://schemas.microsoft.com/office/drawing/2014/main" id="{76CB726D-0FF5-E142-8216-B7E957BBEA4F}"/>
                </a:ext>
              </a:extLst>
            </p:cNvPr>
            <p:cNvSpPr/>
            <p:nvPr/>
          </p:nvSpPr>
          <p:spPr>
            <a:xfrm>
              <a:off x="3902123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2" name="Rectangle 181">
              <a:extLst>
                <a:ext uri="{FF2B5EF4-FFF2-40B4-BE49-F238E27FC236}">
                  <a16:creationId xmlns:a16="http://schemas.microsoft.com/office/drawing/2014/main" id="{816ED7B1-27E2-BD4B-AE4C-62439F9B285D}"/>
                </a:ext>
              </a:extLst>
            </p:cNvPr>
            <p:cNvSpPr/>
            <p:nvPr/>
          </p:nvSpPr>
          <p:spPr>
            <a:xfrm>
              <a:off x="3997373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3" name="Rectangle 182">
              <a:extLst>
                <a:ext uri="{FF2B5EF4-FFF2-40B4-BE49-F238E27FC236}">
                  <a16:creationId xmlns:a16="http://schemas.microsoft.com/office/drawing/2014/main" id="{C0EB5888-6015-A347-8626-C0078961E8A6}"/>
                </a:ext>
              </a:extLst>
            </p:cNvPr>
            <p:cNvSpPr/>
            <p:nvPr/>
          </p:nvSpPr>
          <p:spPr>
            <a:xfrm>
              <a:off x="4092619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4" name="Rectangle 183">
              <a:extLst>
                <a:ext uri="{FF2B5EF4-FFF2-40B4-BE49-F238E27FC236}">
                  <a16:creationId xmlns:a16="http://schemas.microsoft.com/office/drawing/2014/main" id="{7BD4F00C-2B22-E64A-96F9-BA6A73143268}"/>
                </a:ext>
              </a:extLst>
            </p:cNvPr>
            <p:cNvSpPr/>
            <p:nvPr/>
          </p:nvSpPr>
          <p:spPr>
            <a:xfrm>
              <a:off x="4192440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5" name="Rectangle 184">
              <a:extLst>
                <a:ext uri="{FF2B5EF4-FFF2-40B4-BE49-F238E27FC236}">
                  <a16:creationId xmlns:a16="http://schemas.microsoft.com/office/drawing/2014/main" id="{6DEF87D1-6CF1-9340-B95B-B51158692994}"/>
                </a:ext>
              </a:extLst>
            </p:cNvPr>
            <p:cNvSpPr/>
            <p:nvPr/>
          </p:nvSpPr>
          <p:spPr>
            <a:xfrm>
              <a:off x="4287690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6" name="Rectangle 185">
              <a:extLst>
                <a:ext uri="{FF2B5EF4-FFF2-40B4-BE49-F238E27FC236}">
                  <a16:creationId xmlns:a16="http://schemas.microsoft.com/office/drawing/2014/main" id="{ED460973-2EC4-164C-9230-2E2FC437F608}"/>
                </a:ext>
              </a:extLst>
            </p:cNvPr>
            <p:cNvSpPr/>
            <p:nvPr/>
          </p:nvSpPr>
          <p:spPr>
            <a:xfrm>
              <a:off x="4382940" y="1832043"/>
              <a:ext cx="100584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7" name="Rectangle 186">
              <a:extLst>
                <a:ext uri="{FF2B5EF4-FFF2-40B4-BE49-F238E27FC236}">
                  <a16:creationId xmlns:a16="http://schemas.microsoft.com/office/drawing/2014/main" id="{A67A168B-CD07-3A4D-9EC6-39232454EF33}"/>
                </a:ext>
              </a:extLst>
            </p:cNvPr>
            <p:cNvSpPr/>
            <p:nvPr/>
          </p:nvSpPr>
          <p:spPr>
            <a:xfrm>
              <a:off x="4489341" y="1832043"/>
              <a:ext cx="73152" cy="228600"/>
            </a:xfrm>
            <a:prstGeom prst="rect">
              <a:avLst/>
            </a:prstGeom>
            <a:solidFill>
              <a:srgbClr val="339966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10" name="Rectangle 209">
              <a:extLst>
                <a:ext uri="{FF2B5EF4-FFF2-40B4-BE49-F238E27FC236}">
                  <a16:creationId xmlns:a16="http://schemas.microsoft.com/office/drawing/2014/main" id="{CB809839-FBA7-A34A-889F-6C81E2B50E62}"/>
                </a:ext>
              </a:extLst>
            </p:cNvPr>
            <p:cNvSpPr/>
            <p:nvPr/>
          </p:nvSpPr>
          <p:spPr>
            <a:xfrm>
              <a:off x="4558422" y="1832043"/>
              <a:ext cx="73152" cy="228600"/>
            </a:xfrm>
            <a:prstGeom prst="rect">
              <a:avLst/>
            </a:prstGeom>
            <a:solidFill>
              <a:srgbClr val="00FD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11" name="Rectangle 210">
              <a:extLst>
                <a:ext uri="{FF2B5EF4-FFF2-40B4-BE49-F238E27FC236}">
                  <a16:creationId xmlns:a16="http://schemas.microsoft.com/office/drawing/2014/main" id="{6EC4AA36-0010-124D-9947-18E3D87900FC}"/>
                </a:ext>
              </a:extLst>
            </p:cNvPr>
            <p:cNvSpPr/>
            <p:nvPr/>
          </p:nvSpPr>
          <p:spPr>
            <a:xfrm>
              <a:off x="4630469" y="1832043"/>
              <a:ext cx="54864" cy="228600"/>
            </a:xfrm>
            <a:prstGeom prst="rect">
              <a:avLst/>
            </a:prstGeom>
            <a:solidFill>
              <a:srgbClr val="9437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232" name="TextBox 231">
              <a:extLst>
                <a:ext uri="{FF2B5EF4-FFF2-40B4-BE49-F238E27FC236}">
                  <a16:creationId xmlns:a16="http://schemas.microsoft.com/office/drawing/2014/main" id="{5714C15C-920D-A44B-AFC5-6FBA20766FD8}"/>
                </a:ext>
              </a:extLst>
            </p:cNvPr>
            <p:cNvSpPr txBox="1"/>
            <p:nvPr/>
          </p:nvSpPr>
          <p:spPr>
            <a:xfrm>
              <a:off x="533313" y="1627202"/>
              <a:ext cx="81464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eAls2716</a:t>
              </a:r>
            </a:p>
          </p:txBody>
        </p:sp>
        <p:sp>
          <p:nvSpPr>
            <p:cNvPr id="234" name="TextBox 233">
              <a:extLst>
                <a:ext uri="{FF2B5EF4-FFF2-40B4-BE49-F238E27FC236}">
                  <a16:creationId xmlns:a16="http://schemas.microsoft.com/office/drawing/2014/main" id="{AF3BE8F0-B102-1B43-9351-8D93E5A7A09E}"/>
                </a:ext>
              </a:extLst>
            </p:cNvPr>
            <p:cNvSpPr txBox="1"/>
            <p:nvPr/>
          </p:nvSpPr>
          <p:spPr>
            <a:xfrm>
              <a:off x="533313" y="2998713"/>
              <a:ext cx="94929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ELG_04272</a:t>
              </a:r>
            </a:p>
          </p:txBody>
        </p:sp>
        <p:sp>
          <p:nvSpPr>
            <p:cNvPr id="235" name="TextBox 234">
              <a:extLst>
                <a:ext uri="{FF2B5EF4-FFF2-40B4-BE49-F238E27FC236}">
                  <a16:creationId xmlns:a16="http://schemas.microsoft.com/office/drawing/2014/main" id="{8C7D9870-0076-9340-B162-9902FD580602}"/>
                </a:ext>
              </a:extLst>
            </p:cNvPr>
            <p:cNvSpPr txBox="1"/>
            <p:nvPr/>
          </p:nvSpPr>
          <p:spPr>
            <a:xfrm>
              <a:off x="533313" y="1167284"/>
              <a:ext cx="8499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eAls2536 </a:t>
              </a:r>
            </a:p>
          </p:txBody>
        </p:sp>
        <p:sp>
          <p:nvSpPr>
            <p:cNvPr id="302" name="Rectangle 301">
              <a:extLst>
                <a:ext uri="{FF2B5EF4-FFF2-40B4-BE49-F238E27FC236}">
                  <a16:creationId xmlns:a16="http://schemas.microsoft.com/office/drawing/2014/main" id="{5EBEC098-BEDE-C048-9483-573D0A1F313C}"/>
                </a:ext>
              </a:extLst>
            </p:cNvPr>
            <p:cNvSpPr/>
            <p:nvPr/>
          </p:nvSpPr>
          <p:spPr>
            <a:xfrm>
              <a:off x="622524" y="3202771"/>
              <a:ext cx="54864" cy="228600"/>
            </a:xfrm>
            <a:prstGeom prst="rect">
              <a:avLst/>
            </a:prstGeom>
            <a:solidFill>
              <a:srgbClr val="FF7E79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303" name="Rectangle 302">
              <a:extLst>
                <a:ext uri="{FF2B5EF4-FFF2-40B4-BE49-F238E27FC236}">
                  <a16:creationId xmlns:a16="http://schemas.microsoft.com/office/drawing/2014/main" id="{627671DD-F726-0A4F-A320-3002DFF1AFA8}"/>
                </a:ext>
              </a:extLst>
            </p:cNvPr>
            <p:cNvSpPr/>
            <p:nvPr/>
          </p:nvSpPr>
          <p:spPr>
            <a:xfrm>
              <a:off x="679283" y="3202771"/>
              <a:ext cx="457200" cy="228600"/>
            </a:xfrm>
            <a:prstGeom prst="rect">
              <a:avLst/>
            </a:prstGeom>
            <a:solidFill>
              <a:srgbClr val="B2B2B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305" name="Rectangle 304">
              <a:extLst>
                <a:ext uri="{FF2B5EF4-FFF2-40B4-BE49-F238E27FC236}">
                  <a16:creationId xmlns:a16="http://schemas.microsoft.com/office/drawing/2014/main" id="{B10C6112-FE53-6949-BC57-4E64F37DDB5D}"/>
                </a:ext>
              </a:extLst>
            </p:cNvPr>
            <p:cNvSpPr/>
            <p:nvPr/>
          </p:nvSpPr>
          <p:spPr>
            <a:xfrm>
              <a:off x="1139846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06" name="Rectangle 305">
              <a:extLst>
                <a:ext uri="{FF2B5EF4-FFF2-40B4-BE49-F238E27FC236}">
                  <a16:creationId xmlns:a16="http://schemas.microsoft.com/office/drawing/2014/main" id="{E5C7510B-3506-FA42-B74C-CC8F9F55524F}"/>
                </a:ext>
              </a:extLst>
            </p:cNvPr>
            <p:cNvSpPr/>
            <p:nvPr/>
          </p:nvSpPr>
          <p:spPr>
            <a:xfrm>
              <a:off x="1227722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07" name="Rectangle 306">
              <a:extLst>
                <a:ext uri="{FF2B5EF4-FFF2-40B4-BE49-F238E27FC236}">
                  <a16:creationId xmlns:a16="http://schemas.microsoft.com/office/drawing/2014/main" id="{5A049BA4-2887-0249-8DA8-5F3BC38C257E}"/>
                </a:ext>
              </a:extLst>
            </p:cNvPr>
            <p:cNvSpPr/>
            <p:nvPr/>
          </p:nvSpPr>
          <p:spPr>
            <a:xfrm>
              <a:off x="1315598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08" name="Rectangle 307">
              <a:extLst>
                <a:ext uri="{FF2B5EF4-FFF2-40B4-BE49-F238E27FC236}">
                  <a16:creationId xmlns:a16="http://schemas.microsoft.com/office/drawing/2014/main" id="{8BB82904-4718-FE49-9F8F-FE3EBB34C10A}"/>
                </a:ext>
              </a:extLst>
            </p:cNvPr>
            <p:cNvSpPr/>
            <p:nvPr/>
          </p:nvSpPr>
          <p:spPr>
            <a:xfrm>
              <a:off x="1412352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09" name="Rectangle 308">
              <a:extLst>
                <a:ext uri="{FF2B5EF4-FFF2-40B4-BE49-F238E27FC236}">
                  <a16:creationId xmlns:a16="http://schemas.microsoft.com/office/drawing/2014/main" id="{C2DF8A43-B881-4F4C-B6DA-FCA77B7E3371}"/>
                </a:ext>
              </a:extLst>
            </p:cNvPr>
            <p:cNvSpPr/>
            <p:nvPr/>
          </p:nvSpPr>
          <p:spPr>
            <a:xfrm>
              <a:off x="1507602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10" name="Rectangle 309">
              <a:extLst>
                <a:ext uri="{FF2B5EF4-FFF2-40B4-BE49-F238E27FC236}">
                  <a16:creationId xmlns:a16="http://schemas.microsoft.com/office/drawing/2014/main" id="{5FC280B9-F952-8842-903F-CDBA2604F3E8}"/>
                </a:ext>
              </a:extLst>
            </p:cNvPr>
            <p:cNvSpPr/>
            <p:nvPr/>
          </p:nvSpPr>
          <p:spPr>
            <a:xfrm>
              <a:off x="1593974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11" name="Rectangle 310">
              <a:extLst>
                <a:ext uri="{FF2B5EF4-FFF2-40B4-BE49-F238E27FC236}">
                  <a16:creationId xmlns:a16="http://schemas.microsoft.com/office/drawing/2014/main" id="{354D9C5F-C24C-1044-9776-23ABADDCD482}"/>
                </a:ext>
              </a:extLst>
            </p:cNvPr>
            <p:cNvSpPr/>
            <p:nvPr/>
          </p:nvSpPr>
          <p:spPr>
            <a:xfrm>
              <a:off x="1689224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12" name="Rectangle 311">
              <a:extLst>
                <a:ext uri="{FF2B5EF4-FFF2-40B4-BE49-F238E27FC236}">
                  <a16:creationId xmlns:a16="http://schemas.microsoft.com/office/drawing/2014/main" id="{D56356B0-6A30-4E4E-8704-C2DC6389BB70}"/>
                </a:ext>
              </a:extLst>
            </p:cNvPr>
            <p:cNvSpPr/>
            <p:nvPr/>
          </p:nvSpPr>
          <p:spPr>
            <a:xfrm>
              <a:off x="1784474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13" name="Rectangle 312">
              <a:extLst>
                <a:ext uri="{FF2B5EF4-FFF2-40B4-BE49-F238E27FC236}">
                  <a16:creationId xmlns:a16="http://schemas.microsoft.com/office/drawing/2014/main" id="{D7011E76-0597-8B43-9DD0-0B47142C96EA}"/>
                </a:ext>
              </a:extLst>
            </p:cNvPr>
            <p:cNvSpPr/>
            <p:nvPr/>
          </p:nvSpPr>
          <p:spPr>
            <a:xfrm>
              <a:off x="1879724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14" name="Rectangle 313">
              <a:extLst>
                <a:ext uri="{FF2B5EF4-FFF2-40B4-BE49-F238E27FC236}">
                  <a16:creationId xmlns:a16="http://schemas.microsoft.com/office/drawing/2014/main" id="{48017F2D-188A-0542-986D-4D080406614F}"/>
                </a:ext>
              </a:extLst>
            </p:cNvPr>
            <p:cNvSpPr/>
            <p:nvPr/>
          </p:nvSpPr>
          <p:spPr>
            <a:xfrm>
              <a:off x="1974974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15" name="Rectangle 314">
              <a:extLst>
                <a:ext uri="{FF2B5EF4-FFF2-40B4-BE49-F238E27FC236}">
                  <a16:creationId xmlns:a16="http://schemas.microsoft.com/office/drawing/2014/main" id="{433A6CAD-2286-0C45-88D2-FE54F1C3C205}"/>
                </a:ext>
              </a:extLst>
            </p:cNvPr>
            <p:cNvSpPr/>
            <p:nvPr/>
          </p:nvSpPr>
          <p:spPr>
            <a:xfrm>
              <a:off x="2070224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16" name="Rectangle 315">
              <a:extLst>
                <a:ext uri="{FF2B5EF4-FFF2-40B4-BE49-F238E27FC236}">
                  <a16:creationId xmlns:a16="http://schemas.microsoft.com/office/drawing/2014/main" id="{8E6EB4D5-40AB-1444-8006-54A1BBBD1C8B}"/>
                </a:ext>
              </a:extLst>
            </p:cNvPr>
            <p:cNvSpPr/>
            <p:nvPr/>
          </p:nvSpPr>
          <p:spPr>
            <a:xfrm>
              <a:off x="2165474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17" name="Rectangle 316">
              <a:extLst>
                <a:ext uri="{FF2B5EF4-FFF2-40B4-BE49-F238E27FC236}">
                  <a16:creationId xmlns:a16="http://schemas.microsoft.com/office/drawing/2014/main" id="{86AA4E07-573F-C44A-B65A-68B28D3465FE}"/>
                </a:ext>
              </a:extLst>
            </p:cNvPr>
            <p:cNvSpPr/>
            <p:nvPr/>
          </p:nvSpPr>
          <p:spPr>
            <a:xfrm>
              <a:off x="2253350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18" name="Rectangle 317">
              <a:extLst>
                <a:ext uri="{FF2B5EF4-FFF2-40B4-BE49-F238E27FC236}">
                  <a16:creationId xmlns:a16="http://schemas.microsoft.com/office/drawing/2014/main" id="{8FA4E89F-E150-EB4B-B263-C7846512B56F}"/>
                </a:ext>
              </a:extLst>
            </p:cNvPr>
            <p:cNvSpPr/>
            <p:nvPr/>
          </p:nvSpPr>
          <p:spPr>
            <a:xfrm>
              <a:off x="2341226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19" name="Rectangle 318">
              <a:extLst>
                <a:ext uri="{FF2B5EF4-FFF2-40B4-BE49-F238E27FC236}">
                  <a16:creationId xmlns:a16="http://schemas.microsoft.com/office/drawing/2014/main" id="{DAE8AB11-7A6D-7541-ADC6-B9BA1723EACE}"/>
                </a:ext>
              </a:extLst>
            </p:cNvPr>
            <p:cNvSpPr/>
            <p:nvPr/>
          </p:nvSpPr>
          <p:spPr>
            <a:xfrm>
              <a:off x="2429102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20" name="Rectangle 319">
              <a:extLst>
                <a:ext uri="{FF2B5EF4-FFF2-40B4-BE49-F238E27FC236}">
                  <a16:creationId xmlns:a16="http://schemas.microsoft.com/office/drawing/2014/main" id="{C4576AB0-52E5-CB49-BA0A-40CD2811F262}"/>
                </a:ext>
              </a:extLst>
            </p:cNvPr>
            <p:cNvSpPr/>
            <p:nvPr/>
          </p:nvSpPr>
          <p:spPr>
            <a:xfrm>
              <a:off x="2516975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21" name="Rectangle 320">
              <a:extLst>
                <a:ext uri="{FF2B5EF4-FFF2-40B4-BE49-F238E27FC236}">
                  <a16:creationId xmlns:a16="http://schemas.microsoft.com/office/drawing/2014/main" id="{D1409400-5957-C243-B5DB-E2928B1CE43F}"/>
                </a:ext>
              </a:extLst>
            </p:cNvPr>
            <p:cNvSpPr/>
            <p:nvPr/>
          </p:nvSpPr>
          <p:spPr>
            <a:xfrm>
              <a:off x="2606656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22" name="Rectangle 321">
              <a:extLst>
                <a:ext uri="{FF2B5EF4-FFF2-40B4-BE49-F238E27FC236}">
                  <a16:creationId xmlns:a16="http://schemas.microsoft.com/office/drawing/2014/main" id="{60057E65-B016-BA4A-A8E4-F4EDD0EC5591}"/>
                </a:ext>
              </a:extLst>
            </p:cNvPr>
            <p:cNvSpPr/>
            <p:nvPr/>
          </p:nvSpPr>
          <p:spPr>
            <a:xfrm>
              <a:off x="2694532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23" name="Rectangle 322">
              <a:extLst>
                <a:ext uri="{FF2B5EF4-FFF2-40B4-BE49-F238E27FC236}">
                  <a16:creationId xmlns:a16="http://schemas.microsoft.com/office/drawing/2014/main" id="{785E5300-5491-9F4E-BCB0-328CDC070842}"/>
                </a:ext>
              </a:extLst>
            </p:cNvPr>
            <p:cNvSpPr/>
            <p:nvPr/>
          </p:nvSpPr>
          <p:spPr>
            <a:xfrm>
              <a:off x="2782408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24" name="Rectangle 323">
              <a:extLst>
                <a:ext uri="{FF2B5EF4-FFF2-40B4-BE49-F238E27FC236}">
                  <a16:creationId xmlns:a16="http://schemas.microsoft.com/office/drawing/2014/main" id="{68C084C8-33D9-F242-A85C-F7FC857E1325}"/>
                </a:ext>
              </a:extLst>
            </p:cNvPr>
            <p:cNvSpPr/>
            <p:nvPr/>
          </p:nvSpPr>
          <p:spPr>
            <a:xfrm>
              <a:off x="2877658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25" name="Rectangle 324">
              <a:extLst>
                <a:ext uri="{FF2B5EF4-FFF2-40B4-BE49-F238E27FC236}">
                  <a16:creationId xmlns:a16="http://schemas.microsoft.com/office/drawing/2014/main" id="{A425EB8C-A8EA-FC41-9190-953902793C39}"/>
                </a:ext>
              </a:extLst>
            </p:cNvPr>
            <p:cNvSpPr/>
            <p:nvPr/>
          </p:nvSpPr>
          <p:spPr>
            <a:xfrm>
              <a:off x="2972908" y="320277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349" name="Rectangle 348">
              <a:extLst>
                <a:ext uri="{FF2B5EF4-FFF2-40B4-BE49-F238E27FC236}">
                  <a16:creationId xmlns:a16="http://schemas.microsoft.com/office/drawing/2014/main" id="{65C8B04C-49FF-674A-93C4-71C76B8483ED}"/>
                </a:ext>
              </a:extLst>
            </p:cNvPr>
            <p:cNvSpPr/>
            <p:nvPr/>
          </p:nvSpPr>
          <p:spPr>
            <a:xfrm>
              <a:off x="3066894" y="3202771"/>
              <a:ext cx="5367528" cy="228600"/>
            </a:xfrm>
            <a:prstGeom prst="rect">
              <a:avLst/>
            </a:prstGeom>
            <a:solidFill>
              <a:srgbClr val="33CC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388" name="TextBox 387">
              <a:extLst>
                <a:ext uri="{FF2B5EF4-FFF2-40B4-BE49-F238E27FC236}">
                  <a16:creationId xmlns:a16="http://schemas.microsoft.com/office/drawing/2014/main" id="{57A8A9FC-3736-4388-AAC9-3EC3EDB26837}"/>
                </a:ext>
              </a:extLst>
            </p:cNvPr>
            <p:cNvSpPr txBox="1"/>
            <p:nvPr/>
          </p:nvSpPr>
          <p:spPr>
            <a:xfrm>
              <a:off x="524435" y="682311"/>
              <a:ext cx="74411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eAls734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9" name="TextBox 388">
              <a:extLst>
                <a:ext uri="{FF2B5EF4-FFF2-40B4-BE49-F238E27FC236}">
                  <a16:creationId xmlns:a16="http://schemas.microsoft.com/office/drawing/2014/main" id="{7E9FC659-8FDD-4912-AF2D-8DCF529CAF6E}"/>
                </a:ext>
              </a:extLst>
            </p:cNvPr>
            <p:cNvSpPr txBox="1"/>
            <p:nvPr/>
          </p:nvSpPr>
          <p:spPr>
            <a:xfrm>
              <a:off x="533313" y="2088838"/>
              <a:ext cx="8499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eAls2721 </a:t>
              </a:r>
            </a:p>
          </p:txBody>
        </p:sp>
        <p:sp>
          <p:nvSpPr>
            <p:cNvPr id="396" name="TextBox 395">
              <a:extLst>
                <a:ext uri="{FF2B5EF4-FFF2-40B4-BE49-F238E27FC236}">
                  <a16:creationId xmlns:a16="http://schemas.microsoft.com/office/drawing/2014/main" id="{F189A428-D730-4B4C-AFF8-EDAFEBE104A8}"/>
                </a:ext>
              </a:extLst>
            </p:cNvPr>
            <p:cNvSpPr txBox="1"/>
            <p:nvPr/>
          </p:nvSpPr>
          <p:spPr>
            <a:xfrm>
              <a:off x="533313" y="2548658"/>
              <a:ext cx="84991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LeAls5708 </a:t>
              </a:r>
            </a:p>
          </p:txBody>
        </p:sp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1CEC6F3C-A5C6-4B1B-88FC-AA791797D987}"/>
                </a:ext>
              </a:extLst>
            </p:cNvPr>
            <p:cNvGrpSpPr/>
            <p:nvPr/>
          </p:nvGrpSpPr>
          <p:grpSpPr>
            <a:xfrm>
              <a:off x="622524" y="2745863"/>
              <a:ext cx="2598833" cy="228600"/>
              <a:chOff x="324859" y="2685753"/>
              <a:chExt cx="2598833" cy="228600"/>
            </a:xfrm>
          </p:grpSpPr>
          <p:sp>
            <p:nvSpPr>
              <p:cNvPr id="398" name="Rectangle 397">
                <a:extLst>
                  <a:ext uri="{FF2B5EF4-FFF2-40B4-BE49-F238E27FC236}">
                    <a16:creationId xmlns:a16="http://schemas.microsoft.com/office/drawing/2014/main" id="{CEA22B39-CBA2-4004-9BEC-14D30D765765}"/>
                  </a:ext>
                </a:extLst>
              </p:cNvPr>
              <p:cNvSpPr/>
              <p:nvPr/>
            </p:nvSpPr>
            <p:spPr>
              <a:xfrm>
                <a:off x="324859" y="2685753"/>
                <a:ext cx="36576" cy="228600"/>
              </a:xfrm>
              <a:prstGeom prst="rect">
                <a:avLst/>
              </a:prstGeom>
              <a:solidFill>
                <a:srgbClr val="FF7E79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99" name="Rectangle 398">
                <a:extLst>
                  <a:ext uri="{FF2B5EF4-FFF2-40B4-BE49-F238E27FC236}">
                    <a16:creationId xmlns:a16="http://schemas.microsoft.com/office/drawing/2014/main" id="{C2BC0492-5293-4D21-8387-06B911F61A97}"/>
                  </a:ext>
                </a:extLst>
              </p:cNvPr>
              <p:cNvSpPr/>
              <p:nvPr/>
            </p:nvSpPr>
            <p:spPr>
              <a:xfrm>
                <a:off x="358804" y="2685753"/>
                <a:ext cx="932688" cy="228600"/>
              </a:xfrm>
              <a:prstGeom prst="rect">
                <a:avLst/>
              </a:prstGeom>
              <a:solidFill>
                <a:srgbClr val="FF26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400" name="Rectangle 399">
                <a:extLst>
                  <a:ext uri="{FF2B5EF4-FFF2-40B4-BE49-F238E27FC236}">
                    <a16:creationId xmlns:a16="http://schemas.microsoft.com/office/drawing/2014/main" id="{806AF0C2-1DC8-470A-8B0A-A7B220030E94}"/>
                  </a:ext>
                </a:extLst>
              </p:cNvPr>
              <p:cNvSpPr/>
              <p:nvPr/>
            </p:nvSpPr>
            <p:spPr>
              <a:xfrm>
                <a:off x="1288361" y="2685753"/>
                <a:ext cx="1133856" cy="228600"/>
              </a:xfrm>
              <a:prstGeom prst="rect">
                <a:avLst/>
              </a:prstGeom>
              <a:solidFill>
                <a:srgbClr val="00FD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401" name="Rectangle 400">
                <a:extLst>
                  <a:ext uri="{FF2B5EF4-FFF2-40B4-BE49-F238E27FC236}">
                    <a16:creationId xmlns:a16="http://schemas.microsoft.com/office/drawing/2014/main" id="{A5FB4058-F611-4540-92B8-8067559024F1}"/>
                  </a:ext>
                </a:extLst>
              </p:cNvPr>
              <p:cNvSpPr/>
              <p:nvPr/>
            </p:nvSpPr>
            <p:spPr>
              <a:xfrm>
                <a:off x="2416359" y="2685753"/>
                <a:ext cx="438912" cy="228600"/>
              </a:xfrm>
              <a:prstGeom prst="rect">
                <a:avLst/>
              </a:prstGeom>
              <a:solidFill>
                <a:srgbClr val="0432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402" name="Rectangle 401">
                <a:extLst>
                  <a:ext uri="{FF2B5EF4-FFF2-40B4-BE49-F238E27FC236}">
                    <a16:creationId xmlns:a16="http://schemas.microsoft.com/office/drawing/2014/main" id="{E9A536AF-5123-413F-99D3-31736D04FE0C}"/>
                  </a:ext>
                </a:extLst>
              </p:cNvPr>
              <p:cNvSpPr/>
              <p:nvPr/>
            </p:nvSpPr>
            <p:spPr>
              <a:xfrm>
                <a:off x="2850540" y="2685753"/>
                <a:ext cx="73152" cy="228600"/>
              </a:xfrm>
              <a:prstGeom prst="rect">
                <a:avLst/>
              </a:prstGeom>
              <a:solidFill>
                <a:srgbClr val="9437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</p:grp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E2CE28E9-FB42-4987-8B89-2102FE64116D}"/>
                </a:ext>
              </a:extLst>
            </p:cNvPr>
            <p:cNvGrpSpPr/>
            <p:nvPr/>
          </p:nvGrpSpPr>
          <p:grpSpPr>
            <a:xfrm>
              <a:off x="622524" y="1375133"/>
              <a:ext cx="3757337" cy="228600"/>
              <a:chOff x="332527" y="1147358"/>
              <a:chExt cx="3757337" cy="228600"/>
            </a:xfrm>
          </p:grpSpPr>
          <p:sp>
            <p:nvSpPr>
              <p:cNvPr id="351" name="Rectangle 350">
                <a:extLst>
                  <a:ext uri="{FF2B5EF4-FFF2-40B4-BE49-F238E27FC236}">
                    <a16:creationId xmlns:a16="http://schemas.microsoft.com/office/drawing/2014/main" id="{6D9B4BFE-05E3-034B-88CB-71335E9B5235}"/>
                  </a:ext>
                </a:extLst>
              </p:cNvPr>
              <p:cNvSpPr/>
              <p:nvPr/>
            </p:nvSpPr>
            <p:spPr>
              <a:xfrm>
                <a:off x="332527" y="1147358"/>
                <a:ext cx="36576" cy="228600"/>
              </a:xfrm>
              <a:prstGeom prst="rect">
                <a:avLst/>
              </a:prstGeom>
              <a:solidFill>
                <a:srgbClr val="FF7E79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53" name="Rectangle 352">
                <a:extLst>
                  <a:ext uri="{FF2B5EF4-FFF2-40B4-BE49-F238E27FC236}">
                    <a16:creationId xmlns:a16="http://schemas.microsoft.com/office/drawing/2014/main" id="{69A6DD2A-25E4-0440-ABF2-FC49340CA5BE}"/>
                  </a:ext>
                </a:extLst>
              </p:cNvPr>
              <p:cNvSpPr/>
              <p:nvPr/>
            </p:nvSpPr>
            <p:spPr>
              <a:xfrm>
                <a:off x="366472" y="1147358"/>
                <a:ext cx="822960" cy="228600"/>
              </a:xfrm>
              <a:prstGeom prst="rect">
                <a:avLst/>
              </a:prstGeom>
              <a:solidFill>
                <a:srgbClr val="FF26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54" name="Rectangle 353">
                <a:extLst>
                  <a:ext uri="{FF2B5EF4-FFF2-40B4-BE49-F238E27FC236}">
                    <a16:creationId xmlns:a16="http://schemas.microsoft.com/office/drawing/2014/main" id="{611EF73E-40A3-184E-B41A-F5E1D2E8C16F}"/>
                  </a:ext>
                </a:extLst>
              </p:cNvPr>
              <p:cNvSpPr/>
              <p:nvPr/>
            </p:nvSpPr>
            <p:spPr>
              <a:xfrm>
                <a:off x="1188523" y="1147358"/>
                <a:ext cx="1536192" cy="228600"/>
              </a:xfrm>
              <a:prstGeom prst="rect">
                <a:avLst/>
              </a:prstGeom>
              <a:solidFill>
                <a:srgbClr val="00FD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55" name="Rectangle 354">
                <a:extLst>
                  <a:ext uri="{FF2B5EF4-FFF2-40B4-BE49-F238E27FC236}">
                    <a16:creationId xmlns:a16="http://schemas.microsoft.com/office/drawing/2014/main" id="{BD38B845-BC09-CB4F-8454-C4B35FA26239}"/>
                  </a:ext>
                </a:extLst>
              </p:cNvPr>
              <p:cNvSpPr/>
              <p:nvPr/>
            </p:nvSpPr>
            <p:spPr>
              <a:xfrm>
                <a:off x="2724054" y="1147358"/>
                <a:ext cx="1005840" cy="228600"/>
              </a:xfrm>
              <a:prstGeom prst="rect">
                <a:avLst/>
              </a:prstGeom>
              <a:solidFill>
                <a:srgbClr val="FFCC66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56" name="Rectangle 355">
                <a:extLst>
                  <a:ext uri="{FF2B5EF4-FFF2-40B4-BE49-F238E27FC236}">
                    <a16:creationId xmlns:a16="http://schemas.microsoft.com/office/drawing/2014/main" id="{D646CF31-C5F9-CE40-8F41-4F0C9A747AA9}"/>
                  </a:ext>
                </a:extLst>
              </p:cNvPr>
              <p:cNvSpPr/>
              <p:nvPr/>
            </p:nvSpPr>
            <p:spPr>
              <a:xfrm>
                <a:off x="4035000" y="1147358"/>
                <a:ext cx="54864" cy="228600"/>
              </a:xfrm>
              <a:prstGeom prst="rect">
                <a:avLst/>
              </a:prstGeom>
              <a:solidFill>
                <a:srgbClr val="9437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233" name="Rectangle 232">
                <a:extLst>
                  <a:ext uri="{FF2B5EF4-FFF2-40B4-BE49-F238E27FC236}">
                    <a16:creationId xmlns:a16="http://schemas.microsoft.com/office/drawing/2014/main" id="{77C747A9-A8F1-4F14-B8C1-5E5AD8AC42AF}"/>
                  </a:ext>
                </a:extLst>
              </p:cNvPr>
              <p:cNvSpPr/>
              <p:nvPr/>
            </p:nvSpPr>
            <p:spPr>
              <a:xfrm>
                <a:off x="3734604" y="1147358"/>
                <a:ext cx="301752" cy="228600"/>
              </a:xfrm>
              <a:prstGeom prst="rect">
                <a:avLst/>
              </a:prstGeom>
              <a:solidFill>
                <a:srgbClr val="0432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</p:grp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6EFD2948-55DA-4902-90D1-7CB921835D30}"/>
                </a:ext>
              </a:extLst>
            </p:cNvPr>
            <p:cNvGrpSpPr/>
            <p:nvPr/>
          </p:nvGrpSpPr>
          <p:grpSpPr>
            <a:xfrm>
              <a:off x="622524" y="918223"/>
              <a:ext cx="2818099" cy="228600"/>
              <a:chOff x="319722" y="706815"/>
              <a:chExt cx="2818099" cy="228600"/>
            </a:xfrm>
          </p:grpSpPr>
          <p:sp>
            <p:nvSpPr>
              <p:cNvPr id="231" name="Rectangle 230">
                <a:extLst>
                  <a:ext uri="{FF2B5EF4-FFF2-40B4-BE49-F238E27FC236}">
                    <a16:creationId xmlns:a16="http://schemas.microsoft.com/office/drawing/2014/main" id="{1E4C1F27-3CF2-467C-BDE5-42943CE89A2A}"/>
                  </a:ext>
                </a:extLst>
              </p:cNvPr>
              <p:cNvSpPr/>
              <p:nvPr/>
            </p:nvSpPr>
            <p:spPr>
              <a:xfrm>
                <a:off x="319722" y="706815"/>
                <a:ext cx="42672" cy="228600"/>
              </a:xfrm>
              <a:prstGeom prst="rect">
                <a:avLst/>
              </a:prstGeom>
              <a:solidFill>
                <a:srgbClr val="FF7E79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236" name="Rectangle 235">
                <a:extLst>
                  <a:ext uri="{FF2B5EF4-FFF2-40B4-BE49-F238E27FC236}">
                    <a16:creationId xmlns:a16="http://schemas.microsoft.com/office/drawing/2014/main" id="{F3817876-8F7E-4EF4-B356-16F977988B20}"/>
                  </a:ext>
                </a:extLst>
              </p:cNvPr>
              <p:cNvSpPr/>
              <p:nvPr/>
            </p:nvSpPr>
            <p:spPr>
              <a:xfrm>
                <a:off x="362394" y="706815"/>
                <a:ext cx="941832" cy="228600"/>
              </a:xfrm>
              <a:prstGeom prst="rect">
                <a:avLst/>
              </a:prstGeom>
              <a:solidFill>
                <a:srgbClr val="FF26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34" name="Rectangle 333">
                <a:extLst>
                  <a:ext uri="{FF2B5EF4-FFF2-40B4-BE49-F238E27FC236}">
                    <a16:creationId xmlns:a16="http://schemas.microsoft.com/office/drawing/2014/main" id="{F0915F23-7C1E-4995-8FF0-1CC006EE1324}"/>
                  </a:ext>
                </a:extLst>
              </p:cNvPr>
              <p:cNvSpPr/>
              <p:nvPr/>
            </p:nvSpPr>
            <p:spPr>
              <a:xfrm>
                <a:off x="1315410" y="706815"/>
                <a:ext cx="100584" cy="228600"/>
              </a:xfrm>
              <a:prstGeom prst="rect">
                <a:avLst/>
              </a:prstGeom>
              <a:solidFill>
                <a:srgbClr val="33CC33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35" name="Rectangle 334">
                <a:extLst>
                  <a:ext uri="{FF2B5EF4-FFF2-40B4-BE49-F238E27FC236}">
                    <a16:creationId xmlns:a16="http://schemas.microsoft.com/office/drawing/2014/main" id="{45B225F8-567E-489B-A04C-7D62352C35EC}"/>
                  </a:ext>
                </a:extLst>
              </p:cNvPr>
              <p:cNvSpPr/>
              <p:nvPr/>
            </p:nvSpPr>
            <p:spPr>
              <a:xfrm>
                <a:off x="1425408" y="706815"/>
                <a:ext cx="100584" cy="228600"/>
              </a:xfrm>
              <a:prstGeom prst="rect">
                <a:avLst/>
              </a:prstGeom>
              <a:solidFill>
                <a:srgbClr val="33CC33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36" name="Rectangle 335">
                <a:extLst>
                  <a:ext uri="{FF2B5EF4-FFF2-40B4-BE49-F238E27FC236}">
                    <a16:creationId xmlns:a16="http://schemas.microsoft.com/office/drawing/2014/main" id="{92A5DFA5-E24D-4757-8843-7F57766B26D6}"/>
                  </a:ext>
                </a:extLst>
              </p:cNvPr>
              <p:cNvSpPr/>
              <p:nvPr/>
            </p:nvSpPr>
            <p:spPr>
              <a:xfrm>
                <a:off x="1535406" y="706815"/>
                <a:ext cx="100584" cy="228600"/>
              </a:xfrm>
              <a:prstGeom prst="rect">
                <a:avLst/>
              </a:prstGeom>
              <a:solidFill>
                <a:srgbClr val="33CC33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37" name="Rectangle 336">
                <a:extLst>
                  <a:ext uri="{FF2B5EF4-FFF2-40B4-BE49-F238E27FC236}">
                    <a16:creationId xmlns:a16="http://schemas.microsoft.com/office/drawing/2014/main" id="{D4434F1C-13DD-455A-91FC-3AB67C08CEA3}"/>
                  </a:ext>
                </a:extLst>
              </p:cNvPr>
              <p:cNvSpPr/>
              <p:nvPr/>
            </p:nvSpPr>
            <p:spPr>
              <a:xfrm>
                <a:off x="1645404" y="706815"/>
                <a:ext cx="100584" cy="228600"/>
              </a:xfrm>
              <a:prstGeom prst="rect">
                <a:avLst/>
              </a:prstGeom>
              <a:solidFill>
                <a:srgbClr val="33CC33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85" name="Rectangle 384">
                <a:extLst>
                  <a:ext uri="{FF2B5EF4-FFF2-40B4-BE49-F238E27FC236}">
                    <a16:creationId xmlns:a16="http://schemas.microsoft.com/office/drawing/2014/main" id="{3964AB1E-89BB-4939-BB05-809E0962CD26}"/>
                  </a:ext>
                </a:extLst>
              </p:cNvPr>
              <p:cNvSpPr/>
              <p:nvPr/>
            </p:nvSpPr>
            <p:spPr>
              <a:xfrm>
                <a:off x="1858495" y="706815"/>
                <a:ext cx="1216152" cy="228600"/>
              </a:xfrm>
              <a:prstGeom prst="rect">
                <a:avLst/>
              </a:prstGeom>
              <a:solidFill>
                <a:srgbClr val="33CC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87" name="Rectangle 386">
                <a:extLst>
                  <a:ext uri="{FF2B5EF4-FFF2-40B4-BE49-F238E27FC236}">
                    <a16:creationId xmlns:a16="http://schemas.microsoft.com/office/drawing/2014/main" id="{76248F1A-938B-48D3-BA05-9A64B6884635}"/>
                  </a:ext>
                </a:extLst>
              </p:cNvPr>
              <p:cNvSpPr/>
              <p:nvPr/>
            </p:nvSpPr>
            <p:spPr>
              <a:xfrm>
                <a:off x="3082957" y="706815"/>
                <a:ext cx="54864" cy="228600"/>
              </a:xfrm>
              <a:prstGeom prst="rect">
                <a:avLst/>
              </a:prstGeom>
              <a:solidFill>
                <a:srgbClr val="9437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237" name="Rectangle 236">
                <a:extLst>
                  <a:ext uri="{FF2B5EF4-FFF2-40B4-BE49-F238E27FC236}">
                    <a16:creationId xmlns:a16="http://schemas.microsoft.com/office/drawing/2014/main" id="{54F172E1-494E-4D68-94BB-712DA84C81FD}"/>
                  </a:ext>
                </a:extLst>
              </p:cNvPr>
              <p:cNvSpPr/>
              <p:nvPr/>
            </p:nvSpPr>
            <p:spPr>
              <a:xfrm>
                <a:off x="1751588" y="706815"/>
                <a:ext cx="100584" cy="228600"/>
              </a:xfrm>
              <a:prstGeom prst="rect">
                <a:avLst/>
              </a:prstGeom>
              <a:solidFill>
                <a:srgbClr val="33CC33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200" dirty="0"/>
              </a:p>
            </p:txBody>
          </p:sp>
        </p:grp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FD75F90D-FC9B-4F77-BD3B-55FE9EC5770F}"/>
                </a:ext>
              </a:extLst>
            </p:cNvPr>
            <p:cNvGrpSpPr/>
            <p:nvPr/>
          </p:nvGrpSpPr>
          <p:grpSpPr>
            <a:xfrm>
              <a:off x="622524" y="2288953"/>
              <a:ext cx="3197466" cy="228600"/>
              <a:chOff x="340825" y="2215560"/>
              <a:chExt cx="3197466" cy="228600"/>
            </a:xfrm>
          </p:grpSpPr>
          <p:sp>
            <p:nvSpPr>
              <p:cNvPr id="391" name="Rectangle 390">
                <a:extLst>
                  <a:ext uri="{FF2B5EF4-FFF2-40B4-BE49-F238E27FC236}">
                    <a16:creationId xmlns:a16="http://schemas.microsoft.com/office/drawing/2014/main" id="{F19EA347-FE49-47F2-BC6F-A3A184654115}"/>
                  </a:ext>
                </a:extLst>
              </p:cNvPr>
              <p:cNvSpPr/>
              <p:nvPr/>
            </p:nvSpPr>
            <p:spPr>
              <a:xfrm>
                <a:off x="340825" y="2215560"/>
                <a:ext cx="36576" cy="228600"/>
              </a:xfrm>
              <a:prstGeom prst="rect">
                <a:avLst/>
              </a:prstGeom>
              <a:solidFill>
                <a:srgbClr val="FF7E79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92" name="Rectangle 391">
                <a:extLst>
                  <a:ext uri="{FF2B5EF4-FFF2-40B4-BE49-F238E27FC236}">
                    <a16:creationId xmlns:a16="http://schemas.microsoft.com/office/drawing/2014/main" id="{ED5C397F-3312-4AF4-8015-3A80C6EFB726}"/>
                  </a:ext>
                </a:extLst>
              </p:cNvPr>
              <p:cNvSpPr/>
              <p:nvPr/>
            </p:nvSpPr>
            <p:spPr>
              <a:xfrm>
                <a:off x="377612" y="2215560"/>
                <a:ext cx="758952" cy="228600"/>
              </a:xfrm>
              <a:prstGeom prst="rect">
                <a:avLst/>
              </a:prstGeom>
              <a:solidFill>
                <a:srgbClr val="FF26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93" name="Rectangle 392">
                <a:extLst>
                  <a:ext uri="{FF2B5EF4-FFF2-40B4-BE49-F238E27FC236}">
                    <a16:creationId xmlns:a16="http://schemas.microsoft.com/office/drawing/2014/main" id="{36168060-76CB-420E-BCAF-19C421ABD4F1}"/>
                  </a:ext>
                </a:extLst>
              </p:cNvPr>
              <p:cNvSpPr/>
              <p:nvPr/>
            </p:nvSpPr>
            <p:spPr>
              <a:xfrm>
                <a:off x="1136867" y="2215560"/>
                <a:ext cx="978408" cy="228600"/>
              </a:xfrm>
              <a:prstGeom prst="rect">
                <a:avLst/>
              </a:prstGeom>
              <a:solidFill>
                <a:srgbClr val="00FD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94" name="Rectangle 393">
                <a:extLst>
                  <a:ext uri="{FF2B5EF4-FFF2-40B4-BE49-F238E27FC236}">
                    <a16:creationId xmlns:a16="http://schemas.microsoft.com/office/drawing/2014/main" id="{030D53DE-0990-4136-9E6F-8BF3804EFB90}"/>
                  </a:ext>
                </a:extLst>
              </p:cNvPr>
              <p:cNvSpPr/>
              <p:nvPr/>
            </p:nvSpPr>
            <p:spPr>
              <a:xfrm>
                <a:off x="2117454" y="2215560"/>
                <a:ext cx="1124712" cy="228600"/>
              </a:xfrm>
              <a:prstGeom prst="rect">
                <a:avLst/>
              </a:prstGeom>
              <a:solidFill>
                <a:srgbClr val="FFCC66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395" name="Rectangle 394">
                <a:extLst>
                  <a:ext uri="{FF2B5EF4-FFF2-40B4-BE49-F238E27FC236}">
                    <a16:creationId xmlns:a16="http://schemas.microsoft.com/office/drawing/2014/main" id="{C4571992-C1DA-4435-BB43-AAAC2536D9B9}"/>
                  </a:ext>
                </a:extLst>
              </p:cNvPr>
              <p:cNvSpPr/>
              <p:nvPr/>
            </p:nvSpPr>
            <p:spPr>
              <a:xfrm>
                <a:off x="3242613" y="2215560"/>
                <a:ext cx="228600" cy="228600"/>
              </a:xfrm>
              <a:prstGeom prst="rect">
                <a:avLst/>
              </a:prstGeom>
              <a:solidFill>
                <a:srgbClr val="0432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  <p:sp>
            <p:nvSpPr>
              <p:cNvPr id="238" name="Rectangle 237">
                <a:extLst>
                  <a:ext uri="{FF2B5EF4-FFF2-40B4-BE49-F238E27FC236}">
                    <a16:creationId xmlns:a16="http://schemas.microsoft.com/office/drawing/2014/main" id="{9AB41F77-939E-4965-843E-95958C04A1CD}"/>
                  </a:ext>
                </a:extLst>
              </p:cNvPr>
              <p:cNvSpPr/>
              <p:nvPr/>
            </p:nvSpPr>
            <p:spPr>
              <a:xfrm>
                <a:off x="3474283" y="2215560"/>
                <a:ext cx="64008" cy="228600"/>
              </a:xfrm>
              <a:prstGeom prst="rect">
                <a:avLst/>
              </a:prstGeom>
              <a:solidFill>
                <a:srgbClr val="9437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200" dirty="0"/>
              </a:p>
            </p:txBody>
          </p:sp>
        </p:grpSp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01C886CC-55F5-42F9-B132-71A3CF1CA235}"/>
                </a:ext>
              </a:extLst>
            </p:cNvPr>
            <p:cNvGrpSpPr/>
            <p:nvPr/>
          </p:nvGrpSpPr>
          <p:grpSpPr>
            <a:xfrm>
              <a:off x="5287711" y="1193965"/>
              <a:ext cx="3101227" cy="1059761"/>
              <a:chOff x="5287711" y="1193965"/>
              <a:chExt cx="3101227" cy="1059761"/>
            </a:xfrm>
          </p:grpSpPr>
          <p:sp>
            <p:nvSpPr>
              <p:cNvPr id="213" name="Rectangle 212">
                <a:extLst>
                  <a:ext uri="{FF2B5EF4-FFF2-40B4-BE49-F238E27FC236}">
                    <a16:creationId xmlns:a16="http://schemas.microsoft.com/office/drawing/2014/main" id="{85D82ECA-64C8-364E-B94A-3E9EB2090B81}"/>
                  </a:ext>
                </a:extLst>
              </p:cNvPr>
              <p:cNvSpPr/>
              <p:nvPr/>
            </p:nvSpPr>
            <p:spPr>
              <a:xfrm>
                <a:off x="5496321" y="1216462"/>
                <a:ext cx="152400" cy="152400"/>
              </a:xfrm>
              <a:prstGeom prst="rect">
                <a:avLst/>
              </a:prstGeom>
              <a:solidFill>
                <a:srgbClr val="FF7E79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14" name="Rectangle 213">
                <a:extLst>
                  <a:ext uri="{FF2B5EF4-FFF2-40B4-BE49-F238E27FC236}">
                    <a16:creationId xmlns:a16="http://schemas.microsoft.com/office/drawing/2014/main" id="{BB3B86EC-4D9B-2D4D-8275-021DC2AE36F2}"/>
                  </a:ext>
                </a:extLst>
              </p:cNvPr>
              <p:cNvSpPr/>
              <p:nvPr/>
            </p:nvSpPr>
            <p:spPr>
              <a:xfrm>
                <a:off x="5496321" y="1427173"/>
                <a:ext cx="152400" cy="152400"/>
              </a:xfrm>
              <a:prstGeom prst="rect">
                <a:avLst/>
              </a:prstGeom>
              <a:solidFill>
                <a:srgbClr val="FF26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15" name="Rectangle 214">
                <a:extLst>
                  <a:ext uri="{FF2B5EF4-FFF2-40B4-BE49-F238E27FC236}">
                    <a16:creationId xmlns:a16="http://schemas.microsoft.com/office/drawing/2014/main" id="{F8A78A56-44C0-1543-B7BB-40FC448D493A}"/>
                  </a:ext>
                </a:extLst>
              </p:cNvPr>
              <p:cNvSpPr/>
              <p:nvPr/>
            </p:nvSpPr>
            <p:spPr>
              <a:xfrm>
                <a:off x="5496321" y="1845866"/>
                <a:ext cx="152400" cy="152400"/>
              </a:xfrm>
              <a:prstGeom prst="rect">
                <a:avLst/>
              </a:prstGeom>
              <a:solidFill>
                <a:srgbClr val="FFFD78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16" name="Rectangle 215">
                <a:extLst>
                  <a:ext uri="{FF2B5EF4-FFF2-40B4-BE49-F238E27FC236}">
                    <a16:creationId xmlns:a16="http://schemas.microsoft.com/office/drawing/2014/main" id="{19E874DD-9764-0042-BE1A-3A732A05C200}"/>
                  </a:ext>
                </a:extLst>
              </p:cNvPr>
              <p:cNvSpPr/>
              <p:nvPr/>
            </p:nvSpPr>
            <p:spPr>
              <a:xfrm>
                <a:off x="5287711" y="2054340"/>
                <a:ext cx="152400" cy="152400"/>
              </a:xfrm>
              <a:prstGeom prst="rect">
                <a:avLst/>
              </a:prstGeom>
              <a:solidFill>
                <a:srgbClr val="33CC33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17" name="Rectangle 216">
                <a:extLst>
                  <a:ext uri="{FF2B5EF4-FFF2-40B4-BE49-F238E27FC236}">
                    <a16:creationId xmlns:a16="http://schemas.microsoft.com/office/drawing/2014/main" id="{575FE7AE-1F2C-AD42-81C0-990EA16BD30A}"/>
                  </a:ext>
                </a:extLst>
              </p:cNvPr>
              <p:cNvSpPr/>
              <p:nvPr/>
            </p:nvSpPr>
            <p:spPr>
              <a:xfrm>
                <a:off x="7209378" y="1216462"/>
                <a:ext cx="152400" cy="152400"/>
              </a:xfrm>
              <a:prstGeom prst="rect">
                <a:avLst/>
              </a:prstGeom>
              <a:solidFill>
                <a:srgbClr val="33CC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18" name="Rectangle 217">
                <a:extLst>
                  <a:ext uri="{FF2B5EF4-FFF2-40B4-BE49-F238E27FC236}">
                    <a16:creationId xmlns:a16="http://schemas.microsoft.com/office/drawing/2014/main" id="{61471033-8ADD-AE47-942B-7255AC6C78CE}"/>
                  </a:ext>
                </a:extLst>
              </p:cNvPr>
              <p:cNvSpPr/>
              <p:nvPr/>
            </p:nvSpPr>
            <p:spPr>
              <a:xfrm>
                <a:off x="7209378" y="1638770"/>
                <a:ext cx="152400" cy="152400"/>
              </a:xfrm>
              <a:prstGeom prst="rect">
                <a:avLst/>
              </a:prstGeom>
              <a:solidFill>
                <a:srgbClr val="FFCC66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19" name="Rectangle 218">
                <a:extLst>
                  <a:ext uri="{FF2B5EF4-FFF2-40B4-BE49-F238E27FC236}">
                    <a16:creationId xmlns:a16="http://schemas.microsoft.com/office/drawing/2014/main" id="{508E4FDC-86FD-3841-8F25-E5C77E3BD5C2}"/>
                  </a:ext>
                </a:extLst>
              </p:cNvPr>
              <p:cNvSpPr/>
              <p:nvPr/>
            </p:nvSpPr>
            <p:spPr>
              <a:xfrm>
                <a:off x="7209378" y="1845866"/>
                <a:ext cx="152400" cy="152400"/>
              </a:xfrm>
              <a:prstGeom prst="rect">
                <a:avLst/>
              </a:prstGeom>
              <a:solidFill>
                <a:srgbClr val="0432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21" name="Rectangle 220">
                <a:extLst>
                  <a:ext uri="{FF2B5EF4-FFF2-40B4-BE49-F238E27FC236}">
                    <a16:creationId xmlns:a16="http://schemas.microsoft.com/office/drawing/2014/main" id="{4FFF5BFC-BE96-AA46-AFE3-89F16477E32D}"/>
                  </a:ext>
                </a:extLst>
              </p:cNvPr>
              <p:cNvSpPr/>
              <p:nvPr/>
            </p:nvSpPr>
            <p:spPr>
              <a:xfrm>
                <a:off x="7209378" y="2054340"/>
                <a:ext cx="152400" cy="152400"/>
              </a:xfrm>
              <a:prstGeom prst="rect">
                <a:avLst/>
              </a:prstGeom>
              <a:solidFill>
                <a:srgbClr val="9437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22" name="TextBox 221">
                <a:extLst>
                  <a:ext uri="{FF2B5EF4-FFF2-40B4-BE49-F238E27FC236}">
                    <a16:creationId xmlns:a16="http://schemas.microsoft.com/office/drawing/2014/main" id="{9BC578EC-8622-FB44-A5AC-C9170AC276CE}"/>
                  </a:ext>
                </a:extLst>
              </p:cNvPr>
              <p:cNvSpPr txBox="1"/>
              <p:nvPr/>
            </p:nvSpPr>
            <p:spPr>
              <a:xfrm>
                <a:off x="5887657" y="1203490"/>
                <a:ext cx="132119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ecretory Signal Peptide</a:t>
                </a:r>
              </a:p>
            </p:txBody>
          </p:sp>
          <p:sp>
            <p:nvSpPr>
              <p:cNvPr id="223" name="TextBox 222">
                <a:extLst>
                  <a:ext uri="{FF2B5EF4-FFF2-40B4-BE49-F238E27FC236}">
                    <a16:creationId xmlns:a16="http://schemas.microsoft.com/office/drawing/2014/main" id="{F65B413F-95AC-7443-B13B-471F96D74DFE}"/>
                  </a:ext>
                </a:extLst>
              </p:cNvPr>
              <p:cNvSpPr txBox="1"/>
              <p:nvPr/>
            </p:nvSpPr>
            <p:spPr>
              <a:xfrm>
                <a:off x="5887657" y="1416189"/>
                <a:ext cx="58541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T-Als +</a:t>
                </a:r>
              </a:p>
            </p:txBody>
          </p:sp>
          <p:sp>
            <p:nvSpPr>
              <p:cNvPr id="224" name="TextBox 223">
                <a:extLst>
                  <a:ext uri="{FF2B5EF4-FFF2-40B4-BE49-F238E27FC236}">
                    <a16:creationId xmlns:a16="http://schemas.microsoft.com/office/drawing/2014/main" id="{C07241EF-8DD4-FF44-8F99-E9CE27F1A3A8}"/>
                  </a:ext>
                </a:extLst>
              </p:cNvPr>
              <p:cNvSpPr txBox="1"/>
              <p:nvPr/>
            </p:nvSpPr>
            <p:spPr>
              <a:xfrm>
                <a:off x="5887657" y="1834440"/>
                <a:ext cx="1148071" cy="215444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Als Tandem Repeats</a:t>
                </a:r>
              </a:p>
            </p:txBody>
          </p:sp>
          <p:sp>
            <p:nvSpPr>
              <p:cNvPr id="225" name="TextBox 224">
                <a:extLst>
                  <a:ext uri="{FF2B5EF4-FFF2-40B4-BE49-F238E27FC236}">
                    <a16:creationId xmlns:a16="http://schemas.microsoft.com/office/drawing/2014/main" id="{D7BCF7AB-F974-6E4C-9E21-9F49BE335C79}"/>
                  </a:ext>
                </a:extLst>
              </p:cNvPr>
              <p:cNvSpPr txBox="1"/>
              <p:nvPr/>
            </p:nvSpPr>
            <p:spPr>
              <a:xfrm>
                <a:off x="5887657" y="2019232"/>
                <a:ext cx="1279517" cy="215444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Iff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/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yr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 Tandem Repeats</a:t>
                </a:r>
              </a:p>
            </p:txBody>
          </p:sp>
          <p:sp>
            <p:nvSpPr>
              <p:cNvPr id="226" name="TextBox 225">
                <a:extLst>
                  <a:ext uri="{FF2B5EF4-FFF2-40B4-BE49-F238E27FC236}">
                    <a16:creationId xmlns:a16="http://schemas.microsoft.com/office/drawing/2014/main" id="{76565A3D-9FD9-5147-95F0-756FB4CF198F}"/>
                  </a:ext>
                </a:extLst>
              </p:cNvPr>
              <p:cNvSpPr txBox="1"/>
              <p:nvPr/>
            </p:nvSpPr>
            <p:spPr>
              <a:xfrm>
                <a:off x="7417197" y="1193965"/>
                <a:ext cx="62388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EST-Rich</a:t>
                </a:r>
              </a:p>
            </p:txBody>
          </p:sp>
          <p:sp>
            <p:nvSpPr>
              <p:cNvPr id="227" name="TextBox 226">
                <a:extLst>
                  <a:ext uri="{FF2B5EF4-FFF2-40B4-BE49-F238E27FC236}">
                    <a16:creationId xmlns:a16="http://schemas.microsoft.com/office/drawing/2014/main" id="{D3AEA6F3-0062-8248-9A53-95D7E2B3A3E2}"/>
                  </a:ext>
                </a:extLst>
              </p:cNvPr>
              <p:cNvSpPr txBox="1"/>
              <p:nvPr/>
            </p:nvSpPr>
            <p:spPr>
              <a:xfrm>
                <a:off x="7417197" y="2038282"/>
                <a:ext cx="971741" cy="215444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PI Addition Site</a:t>
                </a:r>
              </a:p>
            </p:txBody>
          </p:sp>
          <p:sp>
            <p:nvSpPr>
              <p:cNvPr id="228" name="TextBox 227">
                <a:extLst>
                  <a:ext uri="{FF2B5EF4-FFF2-40B4-BE49-F238E27FC236}">
                    <a16:creationId xmlns:a16="http://schemas.microsoft.com/office/drawing/2014/main" id="{6203B029-4A67-7241-9A4B-9EC4EA617B98}"/>
                  </a:ext>
                </a:extLst>
              </p:cNvPr>
              <p:cNvSpPr txBox="1"/>
              <p:nvPr/>
            </p:nvSpPr>
            <p:spPr>
              <a:xfrm>
                <a:off x="7417197" y="1620886"/>
                <a:ext cx="851515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TDNVP-Rich</a:t>
                </a:r>
              </a:p>
            </p:txBody>
          </p:sp>
          <p:sp>
            <p:nvSpPr>
              <p:cNvPr id="229" name="TextBox 228">
                <a:extLst>
                  <a:ext uri="{FF2B5EF4-FFF2-40B4-BE49-F238E27FC236}">
                    <a16:creationId xmlns:a16="http://schemas.microsoft.com/office/drawing/2014/main" id="{16676433-C7D9-7B4C-A42E-7F6A4E28D745}"/>
                  </a:ext>
                </a:extLst>
              </p:cNvPr>
              <p:cNvSpPr txBox="1"/>
              <p:nvPr/>
            </p:nvSpPr>
            <p:spPr>
              <a:xfrm>
                <a:off x="7417197" y="1829584"/>
                <a:ext cx="554960" cy="215444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T-Rich</a:t>
                </a:r>
              </a:p>
            </p:txBody>
          </p:sp>
          <p:sp>
            <p:nvSpPr>
              <p:cNvPr id="240" name="Rectangle 239">
                <a:extLst>
                  <a:ext uri="{FF2B5EF4-FFF2-40B4-BE49-F238E27FC236}">
                    <a16:creationId xmlns:a16="http://schemas.microsoft.com/office/drawing/2014/main" id="{073A4B16-39B1-489F-B00C-587B721C8A51}"/>
                  </a:ext>
                </a:extLst>
              </p:cNvPr>
              <p:cNvSpPr/>
              <p:nvPr/>
            </p:nvSpPr>
            <p:spPr>
              <a:xfrm>
                <a:off x="5496515" y="2054340"/>
                <a:ext cx="152400" cy="152400"/>
              </a:xfrm>
              <a:prstGeom prst="rect">
                <a:avLst/>
              </a:prstGeom>
              <a:solidFill>
                <a:srgbClr val="339933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41" name="Rectangle 240">
                <a:extLst>
                  <a:ext uri="{FF2B5EF4-FFF2-40B4-BE49-F238E27FC236}">
                    <a16:creationId xmlns:a16="http://schemas.microsoft.com/office/drawing/2014/main" id="{A40330A8-4FCC-431A-A81F-B1F60E0C292B}"/>
                  </a:ext>
                </a:extLst>
              </p:cNvPr>
              <p:cNvSpPr/>
              <p:nvPr/>
            </p:nvSpPr>
            <p:spPr>
              <a:xfrm>
                <a:off x="5705320" y="2054340"/>
                <a:ext cx="152400" cy="152400"/>
              </a:xfrm>
              <a:prstGeom prst="rect">
                <a:avLst/>
              </a:prstGeom>
              <a:solidFill>
                <a:srgbClr val="339966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42" name="Rectangle 241">
                <a:extLst>
                  <a:ext uri="{FF2B5EF4-FFF2-40B4-BE49-F238E27FC236}">
                    <a16:creationId xmlns:a16="http://schemas.microsoft.com/office/drawing/2014/main" id="{502A29FB-28D0-48B7-BD02-1F84F61D5F6D}"/>
                  </a:ext>
                </a:extLst>
              </p:cNvPr>
              <p:cNvSpPr/>
              <p:nvPr/>
            </p:nvSpPr>
            <p:spPr>
              <a:xfrm>
                <a:off x="5496321" y="1638770"/>
                <a:ext cx="152400" cy="152400"/>
              </a:xfrm>
              <a:prstGeom prst="rect">
                <a:avLst/>
              </a:prstGeom>
              <a:solidFill>
                <a:srgbClr val="B2B2B2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243" name="TextBox 242">
                <a:extLst>
                  <a:ext uri="{FF2B5EF4-FFF2-40B4-BE49-F238E27FC236}">
                    <a16:creationId xmlns:a16="http://schemas.microsoft.com/office/drawing/2014/main" id="{59B690FB-28A0-48DC-9E55-4CF5CDD13557}"/>
                  </a:ext>
                </a:extLst>
              </p:cNvPr>
              <p:cNvSpPr txBox="1"/>
              <p:nvPr/>
            </p:nvSpPr>
            <p:spPr>
              <a:xfrm>
                <a:off x="5887657" y="1621347"/>
                <a:ext cx="1249060" cy="215444"/>
              </a:xfrm>
              <a:prstGeom prst="rect">
                <a:avLst/>
              </a:prstGeom>
              <a:noFill/>
              <a:ln w="3175"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NT (like </a:t>
                </a:r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GUG_02520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</a:p>
            </p:txBody>
          </p:sp>
          <p:sp>
            <p:nvSpPr>
              <p:cNvPr id="128" name="Rectangle 127">
                <a:extLst>
                  <a:ext uri="{FF2B5EF4-FFF2-40B4-BE49-F238E27FC236}">
                    <a16:creationId xmlns:a16="http://schemas.microsoft.com/office/drawing/2014/main" id="{0C4BFF2E-2334-498A-A733-1560F378A47D}"/>
                  </a:ext>
                </a:extLst>
              </p:cNvPr>
              <p:cNvSpPr/>
              <p:nvPr/>
            </p:nvSpPr>
            <p:spPr>
              <a:xfrm>
                <a:off x="7209378" y="1427173"/>
                <a:ext cx="152400" cy="152400"/>
              </a:xfrm>
              <a:prstGeom prst="rect">
                <a:avLst/>
              </a:prstGeom>
              <a:solidFill>
                <a:srgbClr val="00FDFF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800" dirty="0"/>
              </a:p>
            </p:txBody>
          </p:sp>
          <p:sp>
            <p:nvSpPr>
              <p:cNvPr id="129" name="TextBox 128">
                <a:extLst>
                  <a:ext uri="{FF2B5EF4-FFF2-40B4-BE49-F238E27FC236}">
                    <a16:creationId xmlns:a16="http://schemas.microsoft.com/office/drawing/2014/main" id="{3251F4A9-BA68-499C-BB90-15DD4104D67F}"/>
                  </a:ext>
                </a:extLst>
              </p:cNvPr>
              <p:cNvSpPr txBox="1"/>
              <p:nvPr/>
            </p:nvSpPr>
            <p:spPr>
              <a:xfrm>
                <a:off x="7417197" y="1402663"/>
                <a:ext cx="6928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EPST</a:t>
                </a:r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-Rich</a:t>
                </a:r>
              </a:p>
            </p:txBody>
          </p:sp>
        </p:grpSp>
        <p:sp>
          <p:nvSpPr>
            <p:cNvPr id="132" name="TextBox 131">
              <a:extLst>
                <a:ext uri="{FF2B5EF4-FFF2-40B4-BE49-F238E27FC236}">
                  <a16:creationId xmlns:a16="http://schemas.microsoft.com/office/drawing/2014/main" id="{52343984-29E7-4F5A-9B70-9D8BDC1F1C3E}"/>
                </a:ext>
              </a:extLst>
            </p:cNvPr>
            <p:cNvSpPr txBox="1"/>
            <p:nvPr/>
          </p:nvSpPr>
          <p:spPr>
            <a:xfrm>
              <a:off x="1141964" y="700124"/>
              <a:ext cx="33874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Gene is on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upercontig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1.1; ~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1,960,000 of 3,549,218 total)</a:t>
              </a:r>
            </a:p>
          </p:txBody>
        </p:sp>
        <p:sp>
          <p:nvSpPr>
            <p:cNvPr id="133" name="TextBox 132">
              <a:extLst>
                <a:ext uri="{FF2B5EF4-FFF2-40B4-BE49-F238E27FC236}">
                  <a16:creationId xmlns:a16="http://schemas.microsoft.com/office/drawing/2014/main" id="{D82B84C6-1F48-476D-97DF-14E8C909151A}"/>
                </a:ext>
              </a:extLst>
            </p:cNvPr>
            <p:cNvSpPr txBox="1"/>
            <p:nvPr/>
          </p:nvSpPr>
          <p:spPr>
            <a:xfrm>
              <a:off x="1214604" y="1173831"/>
              <a:ext cx="326563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Gene is on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upercontig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1.3; ~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594,800 of 2,011,058 total)</a:t>
              </a:r>
            </a:p>
          </p:txBody>
        </p:sp>
        <p:sp>
          <p:nvSpPr>
            <p:cNvPr id="134" name="TextBox 133">
              <a:extLst>
                <a:ext uri="{FF2B5EF4-FFF2-40B4-BE49-F238E27FC236}">
                  <a16:creationId xmlns:a16="http://schemas.microsoft.com/office/drawing/2014/main" id="{6CADED45-FEBA-4DD2-AEAC-1B08DEFD532D}"/>
                </a:ext>
              </a:extLst>
            </p:cNvPr>
            <p:cNvSpPr txBox="1"/>
            <p:nvPr/>
          </p:nvSpPr>
          <p:spPr>
            <a:xfrm>
              <a:off x="1208260" y="1628680"/>
              <a:ext cx="336823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Gene is on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upercontig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1.3; ~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1,057,600 of 2,011,058 total)</a:t>
              </a:r>
            </a:p>
          </p:txBody>
        </p:sp>
        <p:sp>
          <p:nvSpPr>
            <p:cNvPr id="135" name="TextBox 134">
              <a:extLst>
                <a:ext uri="{FF2B5EF4-FFF2-40B4-BE49-F238E27FC236}">
                  <a16:creationId xmlns:a16="http://schemas.microsoft.com/office/drawing/2014/main" id="{EA0674FC-44DF-4349-AFD6-EA4C790F2C0A}"/>
                </a:ext>
              </a:extLst>
            </p:cNvPr>
            <p:cNvSpPr txBox="1"/>
            <p:nvPr/>
          </p:nvSpPr>
          <p:spPr>
            <a:xfrm>
              <a:off x="1210165" y="2082087"/>
              <a:ext cx="338746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Gene is on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upercontig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1.3; ~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1,075,600 of 2,011,058 total)</a:t>
              </a:r>
            </a:p>
          </p:txBody>
        </p:sp>
        <p:sp>
          <p:nvSpPr>
            <p:cNvPr id="136" name="TextBox 135">
              <a:extLst>
                <a:ext uri="{FF2B5EF4-FFF2-40B4-BE49-F238E27FC236}">
                  <a16:creationId xmlns:a16="http://schemas.microsoft.com/office/drawing/2014/main" id="{F3C6FECD-998F-48A8-83ED-2890F0F2EA19}"/>
                </a:ext>
              </a:extLst>
            </p:cNvPr>
            <p:cNvSpPr txBox="1"/>
            <p:nvPr/>
          </p:nvSpPr>
          <p:spPr>
            <a:xfrm>
              <a:off x="1227626" y="2546171"/>
              <a:ext cx="321434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Gene is on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upercontig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1.11; ~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292,000 of 406,919 total)</a:t>
              </a:r>
            </a:p>
          </p:txBody>
        </p:sp>
        <p:sp>
          <p:nvSpPr>
            <p:cNvPr id="137" name="TextBox 136">
              <a:extLst>
                <a:ext uri="{FF2B5EF4-FFF2-40B4-BE49-F238E27FC236}">
                  <a16:creationId xmlns:a16="http://schemas.microsoft.com/office/drawing/2014/main" id="{52AB61B8-D7F7-453B-B13C-7D5E88811735}"/>
                </a:ext>
              </a:extLst>
            </p:cNvPr>
            <p:cNvSpPr txBox="1"/>
            <p:nvPr/>
          </p:nvSpPr>
          <p:spPr>
            <a:xfrm>
              <a:off x="1345097" y="3000757"/>
              <a:ext cx="4881465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Gene is on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upercontig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1.6; ~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 275,000 of 1,248,858 total; predicted protein was 3226 aa)</a:t>
              </a:r>
            </a:p>
          </p:txBody>
        </p:sp>
        <p:sp>
          <p:nvSpPr>
            <p:cNvPr id="138" name="Rectangle 137">
              <a:extLst>
                <a:ext uri="{FF2B5EF4-FFF2-40B4-BE49-F238E27FC236}">
                  <a16:creationId xmlns:a16="http://schemas.microsoft.com/office/drawing/2014/main" id="{C2C580DE-6F66-43BC-9C02-F2948A146D63}"/>
                </a:ext>
              </a:extLst>
            </p:cNvPr>
            <p:cNvSpPr/>
            <p:nvPr/>
          </p:nvSpPr>
          <p:spPr>
            <a:xfrm>
              <a:off x="625211" y="3639431"/>
              <a:ext cx="54864" cy="228600"/>
            </a:xfrm>
            <a:prstGeom prst="rect">
              <a:avLst/>
            </a:prstGeom>
            <a:solidFill>
              <a:srgbClr val="FF7E79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139" name="Rectangle 138">
              <a:extLst>
                <a:ext uri="{FF2B5EF4-FFF2-40B4-BE49-F238E27FC236}">
                  <a16:creationId xmlns:a16="http://schemas.microsoft.com/office/drawing/2014/main" id="{F3F040EC-7277-4E59-8E9F-BE8A7C64A474}"/>
                </a:ext>
              </a:extLst>
            </p:cNvPr>
            <p:cNvSpPr/>
            <p:nvPr/>
          </p:nvSpPr>
          <p:spPr>
            <a:xfrm>
              <a:off x="681970" y="3639431"/>
              <a:ext cx="457200" cy="228600"/>
            </a:xfrm>
            <a:prstGeom prst="rect">
              <a:avLst/>
            </a:prstGeom>
            <a:solidFill>
              <a:srgbClr val="B2B2B2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140" name="Rectangle 139">
              <a:extLst>
                <a:ext uri="{FF2B5EF4-FFF2-40B4-BE49-F238E27FC236}">
                  <a16:creationId xmlns:a16="http://schemas.microsoft.com/office/drawing/2014/main" id="{7F719091-4E76-4404-A2C8-CE5F1C6666B5}"/>
                </a:ext>
              </a:extLst>
            </p:cNvPr>
            <p:cNvSpPr/>
            <p:nvPr/>
          </p:nvSpPr>
          <p:spPr>
            <a:xfrm>
              <a:off x="1142533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41" name="Rectangle 140">
              <a:extLst>
                <a:ext uri="{FF2B5EF4-FFF2-40B4-BE49-F238E27FC236}">
                  <a16:creationId xmlns:a16="http://schemas.microsoft.com/office/drawing/2014/main" id="{1A003EEE-0313-4B87-ABD6-C8664BE87818}"/>
                </a:ext>
              </a:extLst>
            </p:cNvPr>
            <p:cNvSpPr/>
            <p:nvPr/>
          </p:nvSpPr>
          <p:spPr>
            <a:xfrm>
              <a:off x="1230409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42" name="Rectangle 141">
              <a:extLst>
                <a:ext uri="{FF2B5EF4-FFF2-40B4-BE49-F238E27FC236}">
                  <a16:creationId xmlns:a16="http://schemas.microsoft.com/office/drawing/2014/main" id="{67552864-7878-4FC8-A734-6BF3022B7D50}"/>
                </a:ext>
              </a:extLst>
            </p:cNvPr>
            <p:cNvSpPr/>
            <p:nvPr/>
          </p:nvSpPr>
          <p:spPr>
            <a:xfrm>
              <a:off x="1318285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43" name="Rectangle 142">
              <a:extLst>
                <a:ext uri="{FF2B5EF4-FFF2-40B4-BE49-F238E27FC236}">
                  <a16:creationId xmlns:a16="http://schemas.microsoft.com/office/drawing/2014/main" id="{E91690CF-FDA2-495F-B23A-D799773C88D1}"/>
                </a:ext>
              </a:extLst>
            </p:cNvPr>
            <p:cNvSpPr/>
            <p:nvPr/>
          </p:nvSpPr>
          <p:spPr>
            <a:xfrm>
              <a:off x="1415039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44" name="Rectangle 143">
              <a:extLst>
                <a:ext uri="{FF2B5EF4-FFF2-40B4-BE49-F238E27FC236}">
                  <a16:creationId xmlns:a16="http://schemas.microsoft.com/office/drawing/2014/main" id="{6F46CD4E-0DF1-40C6-A076-3F77E79112AD}"/>
                </a:ext>
              </a:extLst>
            </p:cNvPr>
            <p:cNvSpPr/>
            <p:nvPr/>
          </p:nvSpPr>
          <p:spPr>
            <a:xfrm>
              <a:off x="1510289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45" name="Rectangle 144">
              <a:extLst>
                <a:ext uri="{FF2B5EF4-FFF2-40B4-BE49-F238E27FC236}">
                  <a16:creationId xmlns:a16="http://schemas.microsoft.com/office/drawing/2014/main" id="{DE24810A-F27A-4ADF-80F0-EB70FA537634}"/>
                </a:ext>
              </a:extLst>
            </p:cNvPr>
            <p:cNvSpPr/>
            <p:nvPr/>
          </p:nvSpPr>
          <p:spPr>
            <a:xfrm>
              <a:off x="1605539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46" name="Rectangle 145">
              <a:extLst>
                <a:ext uri="{FF2B5EF4-FFF2-40B4-BE49-F238E27FC236}">
                  <a16:creationId xmlns:a16="http://schemas.microsoft.com/office/drawing/2014/main" id="{A6597740-AEFE-4A6E-BBA8-8630C12D7E40}"/>
                </a:ext>
              </a:extLst>
            </p:cNvPr>
            <p:cNvSpPr/>
            <p:nvPr/>
          </p:nvSpPr>
          <p:spPr>
            <a:xfrm>
              <a:off x="1691911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47" name="Rectangle 146">
              <a:extLst>
                <a:ext uri="{FF2B5EF4-FFF2-40B4-BE49-F238E27FC236}">
                  <a16:creationId xmlns:a16="http://schemas.microsoft.com/office/drawing/2014/main" id="{081D81BE-B068-4FE4-A358-5662082D3C49}"/>
                </a:ext>
              </a:extLst>
            </p:cNvPr>
            <p:cNvSpPr/>
            <p:nvPr/>
          </p:nvSpPr>
          <p:spPr>
            <a:xfrm>
              <a:off x="1787161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48" name="Rectangle 147">
              <a:extLst>
                <a:ext uri="{FF2B5EF4-FFF2-40B4-BE49-F238E27FC236}">
                  <a16:creationId xmlns:a16="http://schemas.microsoft.com/office/drawing/2014/main" id="{DBC2BC09-28D1-4C5C-B458-5BEF98DAA145}"/>
                </a:ext>
              </a:extLst>
            </p:cNvPr>
            <p:cNvSpPr/>
            <p:nvPr/>
          </p:nvSpPr>
          <p:spPr>
            <a:xfrm>
              <a:off x="1882411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49" name="Rectangle 148">
              <a:extLst>
                <a:ext uri="{FF2B5EF4-FFF2-40B4-BE49-F238E27FC236}">
                  <a16:creationId xmlns:a16="http://schemas.microsoft.com/office/drawing/2014/main" id="{7783EF5B-E551-4E5B-98FE-F62E77C89CEB}"/>
                </a:ext>
              </a:extLst>
            </p:cNvPr>
            <p:cNvSpPr/>
            <p:nvPr/>
          </p:nvSpPr>
          <p:spPr>
            <a:xfrm>
              <a:off x="1977661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2" name="Rectangle 151">
              <a:extLst>
                <a:ext uri="{FF2B5EF4-FFF2-40B4-BE49-F238E27FC236}">
                  <a16:creationId xmlns:a16="http://schemas.microsoft.com/office/drawing/2014/main" id="{4CE46E8D-3119-476F-9D73-867FAEF0BCEF}"/>
                </a:ext>
              </a:extLst>
            </p:cNvPr>
            <p:cNvSpPr/>
            <p:nvPr/>
          </p:nvSpPr>
          <p:spPr>
            <a:xfrm>
              <a:off x="2072911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3" name="Rectangle 152">
              <a:extLst>
                <a:ext uri="{FF2B5EF4-FFF2-40B4-BE49-F238E27FC236}">
                  <a16:creationId xmlns:a16="http://schemas.microsoft.com/office/drawing/2014/main" id="{ABAFCB6B-06BF-44FB-A2DF-861176CD3935}"/>
                </a:ext>
              </a:extLst>
            </p:cNvPr>
            <p:cNvSpPr/>
            <p:nvPr/>
          </p:nvSpPr>
          <p:spPr>
            <a:xfrm>
              <a:off x="2168161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4" name="Rectangle 153">
              <a:extLst>
                <a:ext uri="{FF2B5EF4-FFF2-40B4-BE49-F238E27FC236}">
                  <a16:creationId xmlns:a16="http://schemas.microsoft.com/office/drawing/2014/main" id="{EE39DEF8-1BD3-4C70-AE85-6E30A9EBAC9C}"/>
                </a:ext>
              </a:extLst>
            </p:cNvPr>
            <p:cNvSpPr/>
            <p:nvPr/>
          </p:nvSpPr>
          <p:spPr>
            <a:xfrm>
              <a:off x="2256037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5" name="Rectangle 154">
              <a:extLst>
                <a:ext uri="{FF2B5EF4-FFF2-40B4-BE49-F238E27FC236}">
                  <a16:creationId xmlns:a16="http://schemas.microsoft.com/office/drawing/2014/main" id="{D9F1BA79-E419-4AD7-BCB7-5EB7DAC7E3BC}"/>
                </a:ext>
              </a:extLst>
            </p:cNvPr>
            <p:cNvSpPr/>
            <p:nvPr/>
          </p:nvSpPr>
          <p:spPr>
            <a:xfrm>
              <a:off x="2343913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56" name="Rectangle 155">
              <a:extLst>
                <a:ext uri="{FF2B5EF4-FFF2-40B4-BE49-F238E27FC236}">
                  <a16:creationId xmlns:a16="http://schemas.microsoft.com/office/drawing/2014/main" id="{DBD8D330-C16E-4BC9-A54E-3B91817B7359}"/>
                </a:ext>
              </a:extLst>
            </p:cNvPr>
            <p:cNvSpPr/>
            <p:nvPr/>
          </p:nvSpPr>
          <p:spPr>
            <a:xfrm>
              <a:off x="2431789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8" name="Rectangle 187">
              <a:extLst>
                <a:ext uri="{FF2B5EF4-FFF2-40B4-BE49-F238E27FC236}">
                  <a16:creationId xmlns:a16="http://schemas.microsoft.com/office/drawing/2014/main" id="{CDB00E47-9609-4899-89CE-92D07DAF0A4D}"/>
                </a:ext>
              </a:extLst>
            </p:cNvPr>
            <p:cNvSpPr/>
            <p:nvPr/>
          </p:nvSpPr>
          <p:spPr>
            <a:xfrm>
              <a:off x="2519662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89" name="Rectangle 188">
              <a:extLst>
                <a:ext uri="{FF2B5EF4-FFF2-40B4-BE49-F238E27FC236}">
                  <a16:creationId xmlns:a16="http://schemas.microsoft.com/office/drawing/2014/main" id="{3AE11909-5EE4-458B-B8FD-E200A9117580}"/>
                </a:ext>
              </a:extLst>
            </p:cNvPr>
            <p:cNvSpPr/>
            <p:nvPr/>
          </p:nvSpPr>
          <p:spPr>
            <a:xfrm>
              <a:off x="2609343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0" name="Rectangle 189">
              <a:extLst>
                <a:ext uri="{FF2B5EF4-FFF2-40B4-BE49-F238E27FC236}">
                  <a16:creationId xmlns:a16="http://schemas.microsoft.com/office/drawing/2014/main" id="{CA433B86-746B-4A6B-9954-1484FD5D54F1}"/>
                </a:ext>
              </a:extLst>
            </p:cNvPr>
            <p:cNvSpPr/>
            <p:nvPr/>
          </p:nvSpPr>
          <p:spPr>
            <a:xfrm>
              <a:off x="2697219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1" name="Rectangle 190">
              <a:extLst>
                <a:ext uri="{FF2B5EF4-FFF2-40B4-BE49-F238E27FC236}">
                  <a16:creationId xmlns:a16="http://schemas.microsoft.com/office/drawing/2014/main" id="{5B6D54BA-1CD3-4731-8E31-5216239A1967}"/>
                </a:ext>
              </a:extLst>
            </p:cNvPr>
            <p:cNvSpPr/>
            <p:nvPr/>
          </p:nvSpPr>
          <p:spPr>
            <a:xfrm>
              <a:off x="2785095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2" name="Rectangle 191">
              <a:extLst>
                <a:ext uri="{FF2B5EF4-FFF2-40B4-BE49-F238E27FC236}">
                  <a16:creationId xmlns:a16="http://schemas.microsoft.com/office/drawing/2014/main" id="{F59602C4-EF15-4922-A831-7FA6EFF7F879}"/>
                </a:ext>
              </a:extLst>
            </p:cNvPr>
            <p:cNvSpPr/>
            <p:nvPr/>
          </p:nvSpPr>
          <p:spPr>
            <a:xfrm>
              <a:off x="2880345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3" name="Rectangle 192">
              <a:extLst>
                <a:ext uri="{FF2B5EF4-FFF2-40B4-BE49-F238E27FC236}">
                  <a16:creationId xmlns:a16="http://schemas.microsoft.com/office/drawing/2014/main" id="{A32B84B0-9632-4A69-80E1-268FCFC2D051}"/>
                </a:ext>
              </a:extLst>
            </p:cNvPr>
            <p:cNvSpPr/>
            <p:nvPr/>
          </p:nvSpPr>
          <p:spPr>
            <a:xfrm>
              <a:off x="2975595" y="3639431"/>
              <a:ext cx="85344" cy="228600"/>
            </a:xfrm>
            <a:prstGeom prst="rect">
              <a:avLst/>
            </a:prstGeom>
            <a:solidFill>
              <a:srgbClr val="FFFD78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4" name="Rectangle 193">
              <a:extLst>
                <a:ext uri="{FF2B5EF4-FFF2-40B4-BE49-F238E27FC236}">
                  <a16:creationId xmlns:a16="http://schemas.microsoft.com/office/drawing/2014/main" id="{173B6D2A-6400-4442-87D0-12E3FF54064F}"/>
                </a:ext>
              </a:extLst>
            </p:cNvPr>
            <p:cNvSpPr/>
            <p:nvPr/>
          </p:nvSpPr>
          <p:spPr>
            <a:xfrm>
              <a:off x="3069581" y="3639431"/>
              <a:ext cx="5669280" cy="228600"/>
            </a:xfrm>
            <a:prstGeom prst="rect">
              <a:avLst/>
            </a:prstGeom>
            <a:solidFill>
              <a:srgbClr val="33CC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200" dirty="0"/>
            </a:p>
          </p:txBody>
        </p:sp>
        <p:sp>
          <p:nvSpPr>
            <p:cNvPr id="195" name="TextBox 194">
              <a:extLst>
                <a:ext uri="{FF2B5EF4-FFF2-40B4-BE49-F238E27FC236}">
                  <a16:creationId xmlns:a16="http://schemas.microsoft.com/office/drawing/2014/main" id="{27F14F89-99DD-402D-978F-DF08C1CD476D}"/>
                </a:ext>
              </a:extLst>
            </p:cNvPr>
            <p:cNvSpPr txBox="1"/>
            <p:nvPr/>
          </p:nvSpPr>
          <p:spPr>
            <a:xfrm>
              <a:off x="551776" y="3431371"/>
              <a:ext cx="335220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Repaired </a:t>
              </a:r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ELG_04272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= </a:t>
              </a:r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ELG_04272</a:t>
              </a:r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+ </a:t>
              </a:r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LELG_04271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Rectangle 195">
              <a:extLst>
                <a:ext uri="{FF2B5EF4-FFF2-40B4-BE49-F238E27FC236}">
                  <a16:creationId xmlns:a16="http://schemas.microsoft.com/office/drawing/2014/main" id="{A7308E60-8E00-4068-9F2D-AA98EA86E0B6}"/>
                </a:ext>
              </a:extLst>
            </p:cNvPr>
            <p:cNvSpPr/>
            <p:nvPr/>
          </p:nvSpPr>
          <p:spPr>
            <a:xfrm>
              <a:off x="8736007" y="3639248"/>
              <a:ext cx="64008" cy="228600"/>
            </a:xfrm>
            <a:prstGeom prst="rect">
              <a:avLst/>
            </a:prstGeom>
            <a:solidFill>
              <a:srgbClr val="9437FF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0960" tIns="30480" rIns="60960" bIns="3048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en-US" sz="1200" dirty="0"/>
            </a:p>
          </p:txBody>
        </p:sp>
        <p:sp>
          <p:nvSpPr>
            <p:cNvPr id="197" name="TextBox 196">
              <a:extLst>
                <a:ext uri="{FF2B5EF4-FFF2-40B4-BE49-F238E27FC236}">
                  <a16:creationId xmlns:a16="http://schemas.microsoft.com/office/drawing/2014/main" id="{AF9E27BF-847F-4E61-9982-30F1ABD46B3C}"/>
                </a:ext>
              </a:extLst>
            </p:cNvPr>
            <p:cNvSpPr txBox="1"/>
            <p:nvPr/>
          </p:nvSpPr>
          <p:spPr>
            <a:xfrm>
              <a:off x="3772853" y="3446852"/>
              <a:ext cx="498726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(3849 aa total; full-length drawing exceeds page size; GenBank accession number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OK172378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cxnSp>
          <p:nvCxnSpPr>
            <p:cNvPr id="14" name="Straight Connector 13">
              <a:extLst>
                <a:ext uri="{FF2B5EF4-FFF2-40B4-BE49-F238E27FC236}">
                  <a16:creationId xmlns:a16="http://schemas.microsoft.com/office/drawing/2014/main" id="{8784C6D3-0A70-4024-8DBC-FADF9CD3324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529656" y="3604532"/>
              <a:ext cx="164429" cy="318356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8" name="Straight Connector 197">
              <a:extLst>
                <a:ext uri="{FF2B5EF4-FFF2-40B4-BE49-F238E27FC236}">
                  <a16:creationId xmlns:a16="http://schemas.microsoft.com/office/drawing/2014/main" id="{8FEF47BD-4120-4D01-9112-A00D6E324B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582370" y="3610854"/>
              <a:ext cx="164429" cy="318356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A04F3558-C501-4360-BD3C-08395FCD6E44}"/>
              </a:ext>
            </a:extLst>
          </p:cNvPr>
          <p:cNvSpPr txBox="1"/>
          <p:nvPr/>
        </p:nvSpPr>
        <p:spPr>
          <a:xfrm>
            <a:off x="420253" y="48723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9" name="TextBox 198">
            <a:extLst>
              <a:ext uri="{FF2B5EF4-FFF2-40B4-BE49-F238E27FC236}">
                <a16:creationId xmlns:a16="http://schemas.microsoft.com/office/drawing/2014/main" id="{49CA2C6B-0F24-4F84-BC63-55C6DC0DDE95}"/>
              </a:ext>
            </a:extLst>
          </p:cNvPr>
          <p:cNvSpPr txBox="1"/>
          <p:nvPr/>
        </p:nvSpPr>
        <p:spPr>
          <a:xfrm>
            <a:off x="1632808" y="455319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9541590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677165E-6841-4086-94F9-FC05AA5EE77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2939502"/>
              </p:ext>
            </p:extLst>
          </p:nvPr>
        </p:nvGraphicFramePr>
        <p:xfrm>
          <a:off x="1775756" y="682603"/>
          <a:ext cx="5592488" cy="1173480"/>
        </p:xfrm>
        <a:graphic>
          <a:graphicData uri="http://schemas.openxmlformats.org/drawingml/2006/table">
            <a:tbl>
              <a:tblPr firstRow="1" firstCol="1" bandRow="1">
                <a:tableStyleId>{2D5ABB26-0587-4C30-8999-92F81FD0307C}</a:tableStyleId>
              </a:tblPr>
              <a:tblGrid>
                <a:gridCol w="818198">
                  <a:extLst>
                    <a:ext uri="{9D8B030D-6E8A-4147-A177-3AD203B41FA5}">
                      <a16:colId xmlns:a16="http://schemas.microsoft.com/office/drawing/2014/main" val="2131190332"/>
                    </a:ext>
                  </a:extLst>
                </a:gridCol>
                <a:gridCol w="795715">
                  <a:extLst>
                    <a:ext uri="{9D8B030D-6E8A-4147-A177-3AD203B41FA5}">
                      <a16:colId xmlns:a16="http://schemas.microsoft.com/office/drawing/2014/main" val="2509173655"/>
                    </a:ext>
                  </a:extLst>
                </a:gridCol>
                <a:gridCol w="795715">
                  <a:extLst>
                    <a:ext uri="{9D8B030D-6E8A-4147-A177-3AD203B41FA5}">
                      <a16:colId xmlns:a16="http://schemas.microsoft.com/office/drawing/2014/main" val="1583704248"/>
                    </a:ext>
                  </a:extLst>
                </a:gridCol>
                <a:gridCol w="795715">
                  <a:extLst>
                    <a:ext uri="{9D8B030D-6E8A-4147-A177-3AD203B41FA5}">
                      <a16:colId xmlns:a16="http://schemas.microsoft.com/office/drawing/2014/main" val="2936704474"/>
                    </a:ext>
                  </a:extLst>
                </a:gridCol>
                <a:gridCol w="795715">
                  <a:extLst>
                    <a:ext uri="{9D8B030D-6E8A-4147-A177-3AD203B41FA5}">
                      <a16:colId xmlns:a16="http://schemas.microsoft.com/office/drawing/2014/main" val="2959378178"/>
                    </a:ext>
                  </a:extLst>
                </a:gridCol>
                <a:gridCol w="795715">
                  <a:extLst>
                    <a:ext uri="{9D8B030D-6E8A-4147-A177-3AD203B41FA5}">
                      <a16:colId xmlns:a16="http://schemas.microsoft.com/office/drawing/2014/main" val="4285163691"/>
                    </a:ext>
                  </a:extLst>
                </a:gridCol>
                <a:gridCol w="795715">
                  <a:extLst>
                    <a:ext uri="{9D8B030D-6E8A-4147-A177-3AD203B41FA5}">
                      <a16:colId xmlns:a16="http://schemas.microsoft.com/office/drawing/2014/main" val="2445785930"/>
                    </a:ext>
                  </a:extLst>
                </a:gridCol>
              </a:tblGrid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 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LeAls734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eAls2536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eAls2716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eAls272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eAls5708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Als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56828127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LeAls734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-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>
                          <a:effectLst/>
                        </a:rPr>
                        <a:t>--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59936531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LeAls2536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9341924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</a:rPr>
                        <a:t>LeAls2716</a:t>
                      </a:r>
                      <a:endParaRPr lang="en-US" sz="11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8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100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</a:rPr>
                        <a:t>--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15225445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eAls2721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0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5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7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4403074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LeAls5708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9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0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7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80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-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4973000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Als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9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3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4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4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5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2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00</a:t>
                      </a: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18811084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99552C5-04F0-49F6-80D7-4DE321F726AD}"/>
              </a:ext>
            </a:extLst>
          </p:cNvPr>
          <p:cNvSpPr txBox="1"/>
          <p:nvPr/>
        </p:nvSpPr>
        <p:spPr>
          <a:xfrm>
            <a:off x="1949327" y="442518"/>
            <a:ext cx="524534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ercent identity values for comparisons between NT-Als sequences in each protein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FC9B8D9-D629-4402-9C86-3720CE1C806F}"/>
              </a:ext>
            </a:extLst>
          </p:cNvPr>
          <p:cNvSpPr txBox="1"/>
          <p:nvPr/>
        </p:nvSpPr>
        <p:spPr>
          <a:xfrm>
            <a:off x="641875" y="2200549"/>
            <a:ext cx="8021358" cy="4339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LE </a:t>
            </a:r>
            <a:r>
              <a:rPr lang="en-US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|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ongisporu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 feature summary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Line drawings to illustrate the basic features of the Als proteins predicted from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ongisporu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ome sequence.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uperconti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ocation of each gene was noted in parentheses following its protein name. Coordinates were based on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SM14968v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ference genome assembly. Approximate nucleotide coordinates were used because regions encoding Als proteins required extensive validation using PCR amplification and Sanger sequencing. A color-coding key and scale bar are shown. The red region in each drawing corresponded to the NT-Als domain as well as sequences immediately C-terminal to that structure (called “NT-Als +” throughout the manuscript). NT-Als + ended where repeated sequences or Ser/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ich sequences began, and in some proteins, included what was called the T (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r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rich) domain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albica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 proteins (reviewed in </a:t>
            </a:r>
            <a:r>
              <a:rPr lang="en-US" sz="12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yer and Cota, 2016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LG_04272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coded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albican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-like tandem repeat sequences but did not have an NT-Als domain, so </a:t>
            </a:r>
            <a:r>
              <a:rPr 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was not given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 Als family name. PCR amplification and Sanger sequencing indicated that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RF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LG_04272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LG_04271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part of the same gene; the corrected gene (GenBank accession number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K172378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encoded both a secretory signal peptide and a GPI anchor addition site suggesting localization of the mature protein in th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ongisporu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wall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ongisporu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 proteins that had repeated sequences in the central domain were recombinants betwee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L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FF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YR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s as previously observed for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mALS2265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metapsilosi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sz="12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h et al., 2019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nsensus tandem repeat sequences from the various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ongisporu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teins compared to those reported previously in other species (Ca =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albican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Cp/Co/Cm =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arapsilosi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.orthopsilosi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C. metapsilosi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Ctr =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tropicalis</a:t>
            </a:r>
            <a:r>
              <a:rPr lang="en-US" sz="12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; Oh et al., 2019; 2021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Conserved amino acids were present in at least 80% of the repeat copies. The lengths of repeated sequences considered in the calculation are shown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ercent identity values for comparisons among the NT-Als sequences for each protein calculated using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lustal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mega (</a:t>
            </a:r>
            <a:r>
              <a:rPr lang="en-US" sz="12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deira et al., 2019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albican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s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as included for reference because its crystallographic structure is known (</a:t>
            </a:r>
            <a:r>
              <a:rPr lang="en-US" sz="12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Lin et al., 2014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r>
              <a:rPr lang="en-US" sz="1200" b="1" u="sng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te: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espite many literature references (e.g. </a:t>
            </a:r>
            <a:r>
              <a:rPr lang="en-US" sz="1200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hen et al., 2018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at indicate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ongisporu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 part of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lade of species that translat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 Ser instead of Leu (Translation Table 12, Alternative Yeast Nuclear code),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B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base uses the standard genetic code (Translation Table 1) for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longisporus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AL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contain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UG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odons. Work presented here used the genes as they are currently translated in the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NCBI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tabase. No substantive changes in conclusions were observed when Translation Table 12 was used instead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93D33A3-CCC9-4F57-AB27-3DC7F76EA916}"/>
              </a:ext>
            </a:extLst>
          </p:cNvPr>
          <p:cNvSpPr txBox="1"/>
          <p:nvPr/>
        </p:nvSpPr>
        <p:spPr>
          <a:xfrm>
            <a:off x="1242807" y="42949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4496108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2</TotalTime>
  <Words>903</Words>
  <Application>Microsoft Office PowerPoint</Application>
  <PresentationFormat>On-screen Show (4:3)</PresentationFormat>
  <Paragraphs>9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Courier New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Lois Hoyer</cp:lastModifiedBy>
  <cp:revision>16</cp:revision>
  <cp:lastPrinted>2021-09-27T20:49:02Z</cp:lastPrinted>
  <dcterms:created xsi:type="dcterms:W3CDTF">2018-02-24T12:42:49Z</dcterms:created>
  <dcterms:modified xsi:type="dcterms:W3CDTF">2021-10-07T21:29:04Z</dcterms:modified>
</cp:coreProperties>
</file>